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9" r:id="rId3"/>
    <p:sldId id="256" r:id="rId4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52031" autoAdjust="0"/>
  </p:normalViewPr>
  <p:slideViewPr>
    <p:cSldViewPr>
      <p:cViewPr>
        <p:scale>
          <a:sx n="80" d="100"/>
          <a:sy n="80" d="100"/>
        </p:scale>
        <p:origin x="-3234" y="-21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0" cy="450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219232-9993-4C97-9A09-AA7A0D8A1003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A9E408-BF56-41A7-B97E-9EDE4BE4A3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3499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A9E408-BF56-41A7-B97E-9EDE4BE4A3B5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92264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ko-KR" dirty="0" smtClean="0"/>
              <a:t>Mouse IAA ELISA Kit  (Cat #EMI0026, </a:t>
            </a:r>
            <a:r>
              <a:rPr lang="en-US" altLang="ko-KR" dirty="0" err="1" smtClean="0"/>
              <a:t>ABclonal</a:t>
            </a:r>
            <a:r>
              <a:rPr lang="en-US" altLang="ko-KR" dirty="0" smtClean="0"/>
              <a:t>, Woburn, MA, USA)</a:t>
            </a:r>
          </a:p>
          <a:p>
            <a:endParaRPr lang="ko-KR" altLang="en-US" dirty="0" smtClean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A9E408-BF56-41A7-B97E-9EDE4BE4A3B5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32784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 smtClean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A9E408-BF56-41A7-B97E-9EDE4BE4A3B5}" type="slidenum">
              <a:rPr lang="ko-KR" altLang="en-US" smtClean="0"/>
              <a:t>3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32784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24673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708527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71292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0533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08467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7024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23749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517634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2713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7715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2337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98845B-F0C4-49BF-B774-23808C692E9E}" type="datetimeFigureOut">
              <a:rPr lang="ko-KR" altLang="en-US" smtClean="0"/>
              <a:t>2020-06-26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F2B67C-8F20-4621-A03E-ECF5DF400A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22007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5" Type="http://schemas.openxmlformats.org/officeDocument/2006/relationships/image" Target="../media/image1.emf"/><Relationship Id="rId10" Type="http://schemas.openxmlformats.org/officeDocument/2006/relationships/image" Target="../media/image6.png"/><Relationship Id="rId4" Type="http://schemas.openxmlformats.org/officeDocument/2006/relationships/oleObject" Target="../embeddings/oleObject1.bin"/><Relationship Id="rId9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11.png"/><Relationship Id="rId5" Type="http://schemas.openxmlformats.org/officeDocument/2006/relationships/image" Target="../media/image7.emf"/><Relationship Id="rId10" Type="http://schemas.openxmlformats.org/officeDocument/2006/relationships/image" Target="../media/image9.emf"/><Relationship Id="rId4" Type="http://schemas.openxmlformats.org/officeDocument/2006/relationships/oleObject" Target="../embeddings/oleObject2.bin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직사각형 21"/>
          <p:cNvSpPr/>
          <p:nvPr/>
        </p:nvSpPr>
        <p:spPr>
          <a:xfrm>
            <a:off x="401168" y="7962807"/>
            <a:ext cx="6055664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Figure S1</a:t>
            </a:r>
            <a:r>
              <a:rPr lang="en-US" altLang="ko-KR" sz="1200" b="1" dirty="0"/>
              <a:t>|</a:t>
            </a:r>
            <a:r>
              <a:rPr lang="en-US" altLang="ko-KR" sz="1200" b="1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Scheme of probiotic administration (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wk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, weeks) .  </a:t>
            </a:r>
            <a:endParaRPr lang="ko-KR" altLang="en-US" sz="1200" dirty="0">
              <a:latin typeface="Times New Roman" panose="02020603050405020304" pitchFamily="18" charset="0"/>
              <a:ea typeface="Arial Unicode MS" panose="020B06040202020202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26" name="그룹 25"/>
          <p:cNvGrpSpPr/>
          <p:nvPr/>
        </p:nvGrpSpPr>
        <p:grpSpPr>
          <a:xfrm>
            <a:off x="234000" y="3358630"/>
            <a:ext cx="6390000" cy="2426740"/>
            <a:chOff x="-36000" y="3090260"/>
            <a:chExt cx="6390000" cy="2426740"/>
          </a:xfrm>
        </p:grpSpPr>
        <p:sp>
          <p:nvSpPr>
            <p:cNvPr id="27" name="아래쪽 화살표 26"/>
            <p:cNvSpPr/>
            <p:nvPr/>
          </p:nvSpPr>
          <p:spPr>
            <a:xfrm>
              <a:off x="3393000" y="3762000"/>
              <a:ext cx="110228" cy="540000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8" name="아래쪽 화살표 27"/>
            <p:cNvSpPr/>
            <p:nvPr/>
          </p:nvSpPr>
          <p:spPr>
            <a:xfrm>
              <a:off x="2279242" y="3921819"/>
              <a:ext cx="110228" cy="380181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" name="아래쪽 화살표 28"/>
            <p:cNvSpPr/>
            <p:nvPr/>
          </p:nvSpPr>
          <p:spPr>
            <a:xfrm>
              <a:off x="5548530" y="3762000"/>
              <a:ext cx="110228" cy="540000"/>
            </a:xfrm>
            <a:prstGeom prst="downArrow">
              <a:avLst/>
            </a:prstGeom>
            <a:solidFill>
              <a:schemeClr val="accent1"/>
            </a:solidFill>
            <a:ln>
              <a:solidFill>
                <a:schemeClr val="accent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30" name="직선 화살표 연결선 29"/>
            <p:cNvCxnSpPr/>
            <p:nvPr/>
          </p:nvCxnSpPr>
          <p:spPr>
            <a:xfrm>
              <a:off x="1998000" y="4565714"/>
              <a:ext cx="3636000" cy="0"/>
            </a:xfrm>
            <a:prstGeom prst="straightConnector1">
              <a:avLst/>
            </a:prstGeom>
            <a:ln w="22225">
              <a:prstDash val="solid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/>
            <p:cNvSpPr txBox="1"/>
            <p:nvPr/>
          </p:nvSpPr>
          <p:spPr>
            <a:xfrm>
              <a:off x="2334600" y="3828260"/>
              <a:ext cx="180583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PBS or IRT5</a:t>
              </a:r>
              <a:endParaRPr lang="ko-KR" altLang="en-US" sz="1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32" name="직선 화살표 연결선 31"/>
            <p:cNvCxnSpPr/>
            <p:nvPr/>
          </p:nvCxnSpPr>
          <p:spPr>
            <a:xfrm>
              <a:off x="1998000" y="5286167"/>
              <a:ext cx="3636000" cy="0"/>
            </a:xfrm>
            <a:prstGeom prst="straightConnector1">
              <a:avLst/>
            </a:prstGeom>
            <a:ln w="22225">
              <a:prstDash val="solid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직사각형 32"/>
            <p:cNvSpPr/>
            <p:nvPr/>
          </p:nvSpPr>
          <p:spPr>
            <a:xfrm>
              <a:off x="-28787" y="4368878"/>
              <a:ext cx="1171347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200" b="1" dirty="0" smtClean="0"/>
                <a:t>Control</a:t>
              </a:r>
            </a:p>
            <a:p>
              <a:pPr algn="ctr"/>
              <a:r>
                <a:rPr lang="en-US" altLang="ko-KR" sz="1200" b="1" dirty="0"/>
                <a:t>g</a:t>
              </a:r>
              <a:r>
                <a:rPr lang="en-US" altLang="ko-KR" sz="1200" b="1" dirty="0" smtClean="0"/>
                <a:t>roup (n=24)</a:t>
              </a:r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-36000" y="5055335"/>
              <a:ext cx="1185774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200" b="1" dirty="0" smtClean="0"/>
                <a:t>Experimental</a:t>
              </a:r>
            </a:p>
            <a:p>
              <a:pPr algn="ctr"/>
              <a:r>
                <a:rPr lang="en-US" altLang="ko-KR" sz="1200" b="1" dirty="0" smtClean="0"/>
                <a:t>group (n=10)</a:t>
              </a:r>
            </a:p>
          </p:txBody>
        </p:sp>
        <p:cxnSp>
          <p:nvCxnSpPr>
            <p:cNvPr id="35" name="직선 연결선 34"/>
            <p:cNvCxnSpPr/>
            <p:nvPr/>
          </p:nvCxnSpPr>
          <p:spPr>
            <a:xfrm>
              <a:off x="1989000" y="4392000"/>
              <a:ext cx="0" cy="360000"/>
            </a:xfrm>
            <a:prstGeom prst="line">
              <a:avLst/>
            </a:prstGeom>
            <a:ln w="25400" cmpd="sng"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6" name="그룹 35"/>
            <p:cNvGrpSpPr/>
            <p:nvPr/>
          </p:nvGrpSpPr>
          <p:grpSpPr>
            <a:xfrm>
              <a:off x="1236473" y="4402171"/>
              <a:ext cx="671743" cy="395078"/>
              <a:chOff x="3446933" y="4624235"/>
              <a:chExt cx="671743" cy="395078"/>
            </a:xfrm>
          </p:grpSpPr>
          <p:sp>
            <p:nvSpPr>
              <p:cNvPr id="50" name="눈물 방울 4"/>
              <p:cNvSpPr/>
              <p:nvPr/>
            </p:nvSpPr>
            <p:spPr>
              <a:xfrm rot="14450210">
                <a:off x="3542721" y="4665229"/>
                <a:ext cx="336836" cy="371331"/>
              </a:xfrm>
              <a:custGeom>
                <a:avLst/>
                <a:gdLst>
                  <a:gd name="connsiteX0" fmla="*/ 0 w 435465"/>
                  <a:gd name="connsiteY0" fmla="*/ 198674 h 397348"/>
                  <a:gd name="connsiteX1" fmla="*/ 217733 w 435465"/>
                  <a:gd name="connsiteY1" fmla="*/ 0 h 397348"/>
                  <a:gd name="connsiteX2" fmla="*/ 408198 w 435465"/>
                  <a:gd name="connsiteY2" fmla="*/ 24880 h 397348"/>
                  <a:gd name="connsiteX3" fmla="*/ 435465 w 435465"/>
                  <a:gd name="connsiteY3" fmla="*/ 198674 h 397348"/>
                  <a:gd name="connsiteX4" fmla="*/ 217732 w 435465"/>
                  <a:gd name="connsiteY4" fmla="*/ 397348 h 397348"/>
                  <a:gd name="connsiteX5" fmla="*/ -1 w 435465"/>
                  <a:gd name="connsiteY5" fmla="*/ 198674 h 397348"/>
                  <a:gd name="connsiteX6" fmla="*/ 0 w 435465"/>
                  <a:gd name="connsiteY6" fmla="*/ 198674 h 397348"/>
                  <a:gd name="connsiteX0" fmla="*/ 1 w 414050"/>
                  <a:gd name="connsiteY0" fmla="*/ 198674 h 397348"/>
                  <a:gd name="connsiteX1" fmla="*/ 217734 w 414050"/>
                  <a:gd name="connsiteY1" fmla="*/ 0 h 397348"/>
                  <a:gd name="connsiteX2" fmla="*/ 408199 w 414050"/>
                  <a:gd name="connsiteY2" fmla="*/ 24880 h 397348"/>
                  <a:gd name="connsiteX3" fmla="*/ 396395 w 414050"/>
                  <a:gd name="connsiteY3" fmla="*/ 122473 h 397348"/>
                  <a:gd name="connsiteX4" fmla="*/ 217733 w 414050"/>
                  <a:gd name="connsiteY4" fmla="*/ 397348 h 397348"/>
                  <a:gd name="connsiteX5" fmla="*/ 0 w 414050"/>
                  <a:gd name="connsiteY5" fmla="*/ 198674 h 397348"/>
                  <a:gd name="connsiteX6" fmla="*/ 1 w 414050"/>
                  <a:gd name="connsiteY6" fmla="*/ 198674 h 397348"/>
                  <a:gd name="connsiteX0" fmla="*/ 1 w 436787"/>
                  <a:gd name="connsiteY0" fmla="*/ 287503 h 486177"/>
                  <a:gd name="connsiteX1" fmla="*/ 217734 w 436787"/>
                  <a:gd name="connsiteY1" fmla="*/ 88829 h 486177"/>
                  <a:gd name="connsiteX2" fmla="*/ 429171 w 436787"/>
                  <a:gd name="connsiteY2" fmla="*/ 3019 h 486177"/>
                  <a:gd name="connsiteX3" fmla="*/ 396395 w 436787"/>
                  <a:gd name="connsiteY3" fmla="*/ 211302 h 486177"/>
                  <a:gd name="connsiteX4" fmla="*/ 217733 w 436787"/>
                  <a:gd name="connsiteY4" fmla="*/ 486177 h 486177"/>
                  <a:gd name="connsiteX5" fmla="*/ 0 w 436787"/>
                  <a:gd name="connsiteY5" fmla="*/ 287503 h 486177"/>
                  <a:gd name="connsiteX6" fmla="*/ 1 w 436787"/>
                  <a:gd name="connsiteY6" fmla="*/ 287503 h 486177"/>
                  <a:gd name="connsiteX0" fmla="*/ 1 w 436787"/>
                  <a:gd name="connsiteY0" fmla="*/ 289492 h 488166"/>
                  <a:gd name="connsiteX1" fmla="*/ 165884 w 436787"/>
                  <a:gd name="connsiteY1" fmla="*/ 61884 h 488166"/>
                  <a:gd name="connsiteX2" fmla="*/ 429171 w 436787"/>
                  <a:gd name="connsiteY2" fmla="*/ 5008 h 488166"/>
                  <a:gd name="connsiteX3" fmla="*/ 396395 w 436787"/>
                  <a:gd name="connsiteY3" fmla="*/ 213291 h 488166"/>
                  <a:gd name="connsiteX4" fmla="*/ 217733 w 436787"/>
                  <a:gd name="connsiteY4" fmla="*/ 488166 h 488166"/>
                  <a:gd name="connsiteX5" fmla="*/ 0 w 436787"/>
                  <a:gd name="connsiteY5" fmla="*/ 289492 h 488166"/>
                  <a:gd name="connsiteX6" fmla="*/ 1 w 436787"/>
                  <a:gd name="connsiteY6" fmla="*/ 289492 h 488166"/>
                  <a:gd name="connsiteX0" fmla="*/ 1 w 437506"/>
                  <a:gd name="connsiteY0" fmla="*/ 289492 h 488166"/>
                  <a:gd name="connsiteX1" fmla="*/ 165884 w 437506"/>
                  <a:gd name="connsiteY1" fmla="*/ 61884 h 488166"/>
                  <a:gd name="connsiteX2" fmla="*/ 429171 w 437506"/>
                  <a:gd name="connsiteY2" fmla="*/ 5008 h 488166"/>
                  <a:gd name="connsiteX3" fmla="*/ 399774 w 437506"/>
                  <a:gd name="connsiteY3" fmla="*/ 255974 h 488166"/>
                  <a:gd name="connsiteX4" fmla="*/ 217733 w 437506"/>
                  <a:gd name="connsiteY4" fmla="*/ 488166 h 488166"/>
                  <a:gd name="connsiteX5" fmla="*/ 0 w 437506"/>
                  <a:gd name="connsiteY5" fmla="*/ 289492 h 488166"/>
                  <a:gd name="connsiteX6" fmla="*/ 1 w 437506"/>
                  <a:gd name="connsiteY6" fmla="*/ 289492 h 48816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437506" h="488166">
                    <a:moveTo>
                      <a:pt x="1" y="289492"/>
                    </a:moveTo>
                    <a:cubicBezTo>
                      <a:pt x="1" y="179767"/>
                      <a:pt x="94356" y="109298"/>
                      <a:pt x="165884" y="61884"/>
                    </a:cubicBezTo>
                    <a:cubicBezTo>
                      <a:pt x="237412" y="14470"/>
                      <a:pt x="365682" y="-11579"/>
                      <a:pt x="429171" y="5008"/>
                    </a:cubicBezTo>
                    <a:cubicBezTo>
                      <a:pt x="447349" y="62939"/>
                      <a:pt x="435014" y="175448"/>
                      <a:pt x="399774" y="255974"/>
                    </a:cubicBezTo>
                    <a:cubicBezTo>
                      <a:pt x="364534" y="336500"/>
                      <a:pt x="337984" y="488166"/>
                      <a:pt x="217733" y="488166"/>
                    </a:cubicBezTo>
                    <a:cubicBezTo>
                      <a:pt x="97482" y="488166"/>
                      <a:pt x="0" y="399217"/>
                      <a:pt x="0" y="289492"/>
                    </a:cubicBezTo>
                    <a:lnTo>
                      <a:pt x="1" y="289492"/>
                    </a:lnTo>
                    <a:close/>
                  </a:path>
                </a:pathLst>
              </a:cu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1" name="자유형 50"/>
              <p:cNvSpPr/>
              <p:nvPr/>
            </p:nvSpPr>
            <p:spPr>
              <a:xfrm>
                <a:off x="3887188" y="4811622"/>
                <a:ext cx="231488" cy="123709"/>
              </a:xfrm>
              <a:custGeom>
                <a:avLst/>
                <a:gdLst>
                  <a:gd name="connsiteX0" fmla="*/ 0 w 391886"/>
                  <a:gd name="connsiteY0" fmla="*/ 56120 h 214766"/>
                  <a:gd name="connsiteX1" fmla="*/ 190006 w 391886"/>
                  <a:gd name="connsiteY1" fmla="*/ 8619 h 214766"/>
                  <a:gd name="connsiteX2" fmla="*/ 296883 w 391886"/>
                  <a:gd name="connsiteY2" fmla="*/ 210499 h 214766"/>
                  <a:gd name="connsiteX3" fmla="*/ 391886 w 391886"/>
                  <a:gd name="connsiteY3" fmla="*/ 151123 h 214766"/>
                  <a:gd name="connsiteX4" fmla="*/ 391886 w 391886"/>
                  <a:gd name="connsiteY4" fmla="*/ 151123 h 214766"/>
                  <a:gd name="connsiteX0" fmla="*/ 0 w 391886"/>
                  <a:gd name="connsiteY0" fmla="*/ 50407 h 145410"/>
                  <a:gd name="connsiteX1" fmla="*/ 190006 w 391886"/>
                  <a:gd name="connsiteY1" fmla="*/ 2906 h 145410"/>
                  <a:gd name="connsiteX2" fmla="*/ 273029 w 391886"/>
                  <a:gd name="connsiteY2" fmla="*/ 117322 h 145410"/>
                  <a:gd name="connsiteX3" fmla="*/ 391886 w 391886"/>
                  <a:gd name="connsiteY3" fmla="*/ 145410 h 145410"/>
                  <a:gd name="connsiteX4" fmla="*/ 391886 w 391886"/>
                  <a:gd name="connsiteY4" fmla="*/ 145410 h 145410"/>
                  <a:gd name="connsiteX0" fmla="*/ 0 w 397416"/>
                  <a:gd name="connsiteY0" fmla="*/ 50407 h 147551"/>
                  <a:gd name="connsiteX1" fmla="*/ 190006 w 397416"/>
                  <a:gd name="connsiteY1" fmla="*/ 2906 h 147551"/>
                  <a:gd name="connsiteX2" fmla="*/ 273029 w 397416"/>
                  <a:gd name="connsiteY2" fmla="*/ 117322 h 147551"/>
                  <a:gd name="connsiteX3" fmla="*/ 391886 w 397416"/>
                  <a:gd name="connsiteY3" fmla="*/ 145410 h 147551"/>
                  <a:gd name="connsiteX4" fmla="*/ 375983 w 397416"/>
                  <a:gd name="connsiteY4" fmla="*/ 73848 h 147551"/>
                  <a:gd name="connsiteX0" fmla="*/ 0 w 448127"/>
                  <a:gd name="connsiteY0" fmla="*/ 50407 h 146130"/>
                  <a:gd name="connsiteX1" fmla="*/ 190006 w 448127"/>
                  <a:gd name="connsiteY1" fmla="*/ 2906 h 146130"/>
                  <a:gd name="connsiteX2" fmla="*/ 273029 w 448127"/>
                  <a:gd name="connsiteY2" fmla="*/ 117322 h 146130"/>
                  <a:gd name="connsiteX3" fmla="*/ 391886 w 448127"/>
                  <a:gd name="connsiteY3" fmla="*/ 145410 h 146130"/>
                  <a:gd name="connsiteX4" fmla="*/ 447545 w 448127"/>
                  <a:gd name="connsiteY4" fmla="*/ 97702 h 146130"/>
                  <a:gd name="connsiteX0" fmla="*/ 0 w 448024"/>
                  <a:gd name="connsiteY0" fmla="*/ 50407 h 125296"/>
                  <a:gd name="connsiteX1" fmla="*/ 190006 w 448024"/>
                  <a:gd name="connsiteY1" fmla="*/ 2906 h 125296"/>
                  <a:gd name="connsiteX2" fmla="*/ 273029 w 448024"/>
                  <a:gd name="connsiteY2" fmla="*/ 117322 h 125296"/>
                  <a:gd name="connsiteX3" fmla="*/ 383934 w 448024"/>
                  <a:gd name="connsiteY3" fmla="*/ 113604 h 125296"/>
                  <a:gd name="connsiteX4" fmla="*/ 447545 w 448024"/>
                  <a:gd name="connsiteY4" fmla="*/ 97702 h 125296"/>
                  <a:gd name="connsiteX0" fmla="*/ 0 w 455913"/>
                  <a:gd name="connsiteY0" fmla="*/ 50407 h 127597"/>
                  <a:gd name="connsiteX1" fmla="*/ 190006 w 455913"/>
                  <a:gd name="connsiteY1" fmla="*/ 2906 h 127597"/>
                  <a:gd name="connsiteX2" fmla="*/ 273029 w 455913"/>
                  <a:gd name="connsiteY2" fmla="*/ 117322 h 127597"/>
                  <a:gd name="connsiteX3" fmla="*/ 383934 w 455913"/>
                  <a:gd name="connsiteY3" fmla="*/ 113604 h 127597"/>
                  <a:gd name="connsiteX4" fmla="*/ 455497 w 455913"/>
                  <a:gd name="connsiteY4" fmla="*/ 42043 h 1275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55913" h="127597">
                    <a:moveTo>
                      <a:pt x="0" y="50407"/>
                    </a:moveTo>
                    <a:cubicBezTo>
                      <a:pt x="70263" y="13791"/>
                      <a:pt x="144501" y="-8247"/>
                      <a:pt x="190006" y="2906"/>
                    </a:cubicBezTo>
                    <a:cubicBezTo>
                      <a:pt x="235511" y="14059"/>
                      <a:pt x="240708" y="98872"/>
                      <a:pt x="273029" y="117322"/>
                    </a:cubicBezTo>
                    <a:cubicBezTo>
                      <a:pt x="305350" y="135772"/>
                      <a:pt x="353523" y="126151"/>
                      <a:pt x="383934" y="113604"/>
                    </a:cubicBezTo>
                    <a:cubicBezTo>
                      <a:pt x="414345" y="101058"/>
                      <a:pt x="460798" y="65897"/>
                      <a:pt x="455497" y="42043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2" name="타원 51"/>
              <p:cNvSpPr/>
              <p:nvPr/>
            </p:nvSpPr>
            <p:spPr>
              <a:xfrm>
                <a:off x="3598331" y="4624235"/>
                <a:ext cx="164304" cy="166298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3" name="순서도: 연결자 52"/>
              <p:cNvSpPr/>
              <p:nvPr/>
            </p:nvSpPr>
            <p:spPr>
              <a:xfrm>
                <a:off x="3543551" y="4795512"/>
                <a:ext cx="27384" cy="27716"/>
              </a:xfrm>
              <a:prstGeom prst="flowChartConnector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4" name="순서도: 수행의 시작/종료 53"/>
              <p:cNvSpPr/>
              <p:nvPr/>
            </p:nvSpPr>
            <p:spPr>
              <a:xfrm>
                <a:off x="3605639" y="4823235"/>
                <a:ext cx="82152" cy="27716"/>
              </a:xfrm>
              <a:prstGeom prst="flowChartTerminator">
                <a:avLst/>
              </a:prstGeom>
              <a:solidFill>
                <a:schemeClr val="tx1"/>
              </a:solidFill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5" name="순서도: 연결자 54"/>
              <p:cNvSpPr/>
              <p:nvPr/>
            </p:nvSpPr>
            <p:spPr>
              <a:xfrm>
                <a:off x="3446933" y="4783905"/>
                <a:ext cx="27384" cy="27716"/>
              </a:xfrm>
              <a:prstGeom prst="flowChartConnector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6" name="순서도: 수행의 시작/종료 55"/>
              <p:cNvSpPr/>
              <p:nvPr/>
            </p:nvSpPr>
            <p:spPr>
              <a:xfrm>
                <a:off x="3605639" y="4855101"/>
                <a:ext cx="82152" cy="27716"/>
              </a:xfrm>
              <a:prstGeom prst="flowChartTerminator">
                <a:avLst/>
              </a:prstGeom>
              <a:solidFill>
                <a:schemeClr val="tx1"/>
              </a:solidFill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37" name="그룹 36"/>
            <p:cNvGrpSpPr/>
            <p:nvPr/>
          </p:nvGrpSpPr>
          <p:grpSpPr>
            <a:xfrm>
              <a:off x="1236473" y="5088628"/>
              <a:ext cx="671743" cy="395078"/>
              <a:chOff x="3446933" y="4624235"/>
              <a:chExt cx="671743" cy="395078"/>
            </a:xfrm>
          </p:grpSpPr>
          <p:sp>
            <p:nvSpPr>
              <p:cNvPr id="43" name="눈물 방울 4"/>
              <p:cNvSpPr/>
              <p:nvPr/>
            </p:nvSpPr>
            <p:spPr>
              <a:xfrm rot="14450210">
                <a:off x="3542721" y="4665229"/>
                <a:ext cx="336836" cy="371331"/>
              </a:xfrm>
              <a:custGeom>
                <a:avLst/>
                <a:gdLst>
                  <a:gd name="connsiteX0" fmla="*/ 0 w 435465"/>
                  <a:gd name="connsiteY0" fmla="*/ 198674 h 397348"/>
                  <a:gd name="connsiteX1" fmla="*/ 217733 w 435465"/>
                  <a:gd name="connsiteY1" fmla="*/ 0 h 397348"/>
                  <a:gd name="connsiteX2" fmla="*/ 408198 w 435465"/>
                  <a:gd name="connsiteY2" fmla="*/ 24880 h 397348"/>
                  <a:gd name="connsiteX3" fmla="*/ 435465 w 435465"/>
                  <a:gd name="connsiteY3" fmla="*/ 198674 h 397348"/>
                  <a:gd name="connsiteX4" fmla="*/ 217732 w 435465"/>
                  <a:gd name="connsiteY4" fmla="*/ 397348 h 397348"/>
                  <a:gd name="connsiteX5" fmla="*/ -1 w 435465"/>
                  <a:gd name="connsiteY5" fmla="*/ 198674 h 397348"/>
                  <a:gd name="connsiteX6" fmla="*/ 0 w 435465"/>
                  <a:gd name="connsiteY6" fmla="*/ 198674 h 397348"/>
                  <a:gd name="connsiteX0" fmla="*/ 1 w 414050"/>
                  <a:gd name="connsiteY0" fmla="*/ 198674 h 397348"/>
                  <a:gd name="connsiteX1" fmla="*/ 217734 w 414050"/>
                  <a:gd name="connsiteY1" fmla="*/ 0 h 397348"/>
                  <a:gd name="connsiteX2" fmla="*/ 408199 w 414050"/>
                  <a:gd name="connsiteY2" fmla="*/ 24880 h 397348"/>
                  <a:gd name="connsiteX3" fmla="*/ 396395 w 414050"/>
                  <a:gd name="connsiteY3" fmla="*/ 122473 h 397348"/>
                  <a:gd name="connsiteX4" fmla="*/ 217733 w 414050"/>
                  <a:gd name="connsiteY4" fmla="*/ 397348 h 397348"/>
                  <a:gd name="connsiteX5" fmla="*/ 0 w 414050"/>
                  <a:gd name="connsiteY5" fmla="*/ 198674 h 397348"/>
                  <a:gd name="connsiteX6" fmla="*/ 1 w 414050"/>
                  <a:gd name="connsiteY6" fmla="*/ 198674 h 397348"/>
                  <a:gd name="connsiteX0" fmla="*/ 1 w 436787"/>
                  <a:gd name="connsiteY0" fmla="*/ 287503 h 486177"/>
                  <a:gd name="connsiteX1" fmla="*/ 217734 w 436787"/>
                  <a:gd name="connsiteY1" fmla="*/ 88829 h 486177"/>
                  <a:gd name="connsiteX2" fmla="*/ 429171 w 436787"/>
                  <a:gd name="connsiteY2" fmla="*/ 3019 h 486177"/>
                  <a:gd name="connsiteX3" fmla="*/ 396395 w 436787"/>
                  <a:gd name="connsiteY3" fmla="*/ 211302 h 486177"/>
                  <a:gd name="connsiteX4" fmla="*/ 217733 w 436787"/>
                  <a:gd name="connsiteY4" fmla="*/ 486177 h 486177"/>
                  <a:gd name="connsiteX5" fmla="*/ 0 w 436787"/>
                  <a:gd name="connsiteY5" fmla="*/ 287503 h 486177"/>
                  <a:gd name="connsiteX6" fmla="*/ 1 w 436787"/>
                  <a:gd name="connsiteY6" fmla="*/ 287503 h 486177"/>
                  <a:gd name="connsiteX0" fmla="*/ 1 w 436787"/>
                  <a:gd name="connsiteY0" fmla="*/ 289492 h 488166"/>
                  <a:gd name="connsiteX1" fmla="*/ 165884 w 436787"/>
                  <a:gd name="connsiteY1" fmla="*/ 61884 h 488166"/>
                  <a:gd name="connsiteX2" fmla="*/ 429171 w 436787"/>
                  <a:gd name="connsiteY2" fmla="*/ 5008 h 488166"/>
                  <a:gd name="connsiteX3" fmla="*/ 396395 w 436787"/>
                  <a:gd name="connsiteY3" fmla="*/ 213291 h 488166"/>
                  <a:gd name="connsiteX4" fmla="*/ 217733 w 436787"/>
                  <a:gd name="connsiteY4" fmla="*/ 488166 h 488166"/>
                  <a:gd name="connsiteX5" fmla="*/ 0 w 436787"/>
                  <a:gd name="connsiteY5" fmla="*/ 289492 h 488166"/>
                  <a:gd name="connsiteX6" fmla="*/ 1 w 436787"/>
                  <a:gd name="connsiteY6" fmla="*/ 289492 h 488166"/>
                  <a:gd name="connsiteX0" fmla="*/ 1 w 437506"/>
                  <a:gd name="connsiteY0" fmla="*/ 289492 h 488166"/>
                  <a:gd name="connsiteX1" fmla="*/ 165884 w 437506"/>
                  <a:gd name="connsiteY1" fmla="*/ 61884 h 488166"/>
                  <a:gd name="connsiteX2" fmla="*/ 429171 w 437506"/>
                  <a:gd name="connsiteY2" fmla="*/ 5008 h 488166"/>
                  <a:gd name="connsiteX3" fmla="*/ 399774 w 437506"/>
                  <a:gd name="connsiteY3" fmla="*/ 255974 h 488166"/>
                  <a:gd name="connsiteX4" fmla="*/ 217733 w 437506"/>
                  <a:gd name="connsiteY4" fmla="*/ 488166 h 488166"/>
                  <a:gd name="connsiteX5" fmla="*/ 0 w 437506"/>
                  <a:gd name="connsiteY5" fmla="*/ 289492 h 488166"/>
                  <a:gd name="connsiteX6" fmla="*/ 1 w 437506"/>
                  <a:gd name="connsiteY6" fmla="*/ 289492 h 48816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437506" h="488166">
                    <a:moveTo>
                      <a:pt x="1" y="289492"/>
                    </a:moveTo>
                    <a:cubicBezTo>
                      <a:pt x="1" y="179767"/>
                      <a:pt x="94356" y="109298"/>
                      <a:pt x="165884" y="61884"/>
                    </a:cubicBezTo>
                    <a:cubicBezTo>
                      <a:pt x="237412" y="14470"/>
                      <a:pt x="365682" y="-11579"/>
                      <a:pt x="429171" y="5008"/>
                    </a:cubicBezTo>
                    <a:cubicBezTo>
                      <a:pt x="447349" y="62939"/>
                      <a:pt x="435014" y="175448"/>
                      <a:pt x="399774" y="255974"/>
                    </a:cubicBezTo>
                    <a:cubicBezTo>
                      <a:pt x="364534" y="336500"/>
                      <a:pt x="337984" y="488166"/>
                      <a:pt x="217733" y="488166"/>
                    </a:cubicBezTo>
                    <a:cubicBezTo>
                      <a:pt x="97482" y="488166"/>
                      <a:pt x="0" y="399217"/>
                      <a:pt x="0" y="289492"/>
                    </a:cubicBezTo>
                    <a:lnTo>
                      <a:pt x="1" y="289492"/>
                    </a:lnTo>
                    <a:close/>
                  </a:path>
                </a:pathLst>
              </a:cu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4" name="자유형 43"/>
              <p:cNvSpPr/>
              <p:nvPr/>
            </p:nvSpPr>
            <p:spPr>
              <a:xfrm>
                <a:off x="3887188" y="4811622"/>
                <a:ext cx="231488" cy="123709"/>
              </a:xfrm>
              <a:custGeom>
                <a:avLst/>
                <a:gdLst>
                  <a:gd name="connsiteX0" fmla="*/ 0 w 391886"/>
                  <a:gd name="connsiteY0" fmla="*/ 56120 h 214766"/>
                  <a:gd name="connsiteX1" fmla="*/ 190006 w 391886"/>
                  <a:gd name="connsiteY1" fmla="*/ 8619 h 214766"/>
                  <a:gd name="connsiteX2" fmla="*/ 296883 w 391886"/>
                  <a:gd name="connsiteY2" fmla="*/ 210499 h 214766"/>
                  <a:gd name="connsiteX3" fmla="*/ 391886 w 391886"/>
                  <a:gd name="connsiteY3" fmla="*/ 151123 h 214766"/>
                  <a:gd name="connsiteX4" fmla="*/ 391886 w 391886"/>
                  <a:gd name="connsiteY4" fmla="*/ 151123 h 214766"/>
                  <a:gd name="connsiteX0" fmla="*/ 0 w 391886"/>
                  <a:gd name="connsiteY0" fmla="*/ 50407 h 145410"/>
                  <a:gd name="connsiteX1" fmla="*/ 190006 w 391886"/>
                  <a:gd name="connsiteY1" fmla="*/ 2906 h 145410"/>
                  <a:gd name="connsiteX2" fmla="*/ 273029 w 391886"/>
                  <a:gd name="connsiteY2" fmla="*/ 117322 h 145410"/>
                  <a:gd name="connsiteX3" fmla="*/ 391886 w 391886"/>
                  <a:gd name="connsiteY3" fmla="*/ 145410 h 145410"/>
                  <a:gd name="connsiteX4" fmla="*/ 391886 w 391886"/>
                  <a:gd name="connsiteY4" fmla="*/ 145410 h 145410"/>
                  <a:gd name="connsiteX0" fmla="*/ 0 w 397416"/>
                  <a:gd name="connsiteY0" fmla="*/ 50407 h 147551"/>
                  <a:gd name="connsiteX1" fmla="*/ 190006 w 397416"/>
                  <a:gd name="connsiteY1" fmla="*/ 2906 h 147551"/>
                  <a:gd name="connsiteX2" fmla="*/ 273029 w 397416"/>
                  <a:gd name="connsiteY2" fmla="*/ 117322 h 147551"/>
                  <a:gd name="connsiteX3" fmla="*/ 391886 w 397416"/>
                  <a:gd name="connsiteY3" fmla="*/ 145410 h 147551"/>
                  <a:gd name="connsiteX4" fmla="*/ 375983 w 397416"/>
                  <a:gd name="connsiteY4" fmla="*/ 73848 h 147551"/>
                  <a:gd name="connsiteX0" fmla="*/ 0 w 448127"/>
                  <a:gd name="connsiteY0" fmla="*/ 50407 h 146130"/>
                  <a:gd name="connsiteX1" fmla="*/ 190006 w 448127"/>
                  <a:gd name="connsiteY1" fmla="*/ 2906 h 146130"/>
                  <a:gd name="connsiteX2" fmla="*/ 273029 w 448127"/>
                  <a:gd name="connsiteY2" fmla="*/ 117322 h 146130"/>
                  <a:gd name="connsiteX3" fmla="*/ 391886 w 448127"/>
                  <a:gd name="connsiteY3" fmla="*/ 145410 h 146130"/>
                  <a:gd name="connsiteX4" fmla="*/ 447545 w 448127"/>
                  <a:gd name="connsiteY4" fmla="*/ 97702 h 146130"/>
                  <a:gd name="connsiteX0" fmla="*/ 0 w 448024"/>
                  <a:gd name="connsiteY0" fmla="*/ 50407 h 125296"/>
                  <a:gd name="connsiteX1" fmla="*/ 190006 w 448024"/>
                  <a:gd name="connsiteY1" fmla="*/ 2906 h 125296"/>
                  <a:gd name="connsiteX2" fmla="*/ 273029 w 448024"/>
                  <a:gd name="connsiteY2" fmla="*/ 117322 h 125296"/>
                  <a:gd name="connsiteX3" fmla="*/ 383934 w 448024"/>
                  <a:gd name="connsiteY3" fmla="*/ 113604 h 125296"/>
                  <a:gd name="connsiteX4" fmla="*/ 447545 w 448024"/>
                  <a:gd name="connsiteY4" fmla="*/ 97702 h 125296"/>
                  <a:gd name="connsiteX0" fmla="*/ 0 w 455913"/>
                  <a:gd name="connsiteY0" fmla="*/ 50407 h 127597"/>
                  <a:gd name="connsiteX1" fmla="*/ 190006 w 455913"/>
                  <a:gd name="connsiteY1" fmla="*/ 2906 h 127597"/>
                  <a:gd name="connsiteX2" fmla="*/ 273029 w 455913"/>
                  <a:gd name="connsiteY2" fmla="*/ 117322 h 127597"/>
                  <a:gd name="connsiteX3" fmla="*/ 383934 w 455913"/>
                  <a:gd name="connsiteY3" fmla="*/ 113604 h 127597"/>
                  <a:gd name="connsiteX4" fmla="*/ 455497 w 455913"/>
                  <a:gd name="connsiteY4" fmla="*/ 42043 h 12759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55913" h="127597">
                    <a:moveTo>
                      <a:pt x="0" y="50407"/>
                    </a:moveTo>
                    <a:cubicBezTo>
                      <a:pt x="70263" y="13791"/>
                      <a:pt x="144501" y="-8247"/>
                      <a:pt x="190006" y="2906"/>
                    </a:cubicBezTo>
                    <a:cubicBezTo>
                      <a:pt x="235511" y="14059"/>
                      <a:pt x="240708" y="98872"/>
                      <a:pt x="273029" y="117322"/>
                    </a:cubicBezTo>
                    <a:cubicBezTo>
                      <a:pt x="305350" y="135772"/>
                      <a:pt x="353523" y="126151"/>
                      <a:pt x="383934" y="113604"/>
                    </a:cubicBezTo>
                    <a:cubicBezTo>
                      <a:pt x="414345" y="101058"/>
                      <a:pt x="460798" y="65897"/>
                      <a:pt x="455497" y="42043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5" name="타원 44"/>
              <p:cNvSpPr/>
              <p:nvPr/>
            </p:nvSpPr>
            <p:spPr>
              <a:xfrm>
                <a:off x="3598331" y="4624235"/>
                <a:ext cx="164304" cy="166298"/>
              </a:xfrm>
              <a:prstGeom prst="ellipse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6" name="순서도: 연결자 45"/>
              <p:cNvSpPr/>
              <p:nvPr/>
            </p:nvSpPr>
            <p:spPr>
              <a:xfrm>
                <a:off x="3543551" y="4795512"/>
                <a:ext cx="27384" cy="27716"/>
              </a:xfrm>
              <a:prstGeom prst="flowChartConnector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7" name="순서도: 수행의 시작/종료 46"/>
              <p:cNvSpPr/>
              <p:nvPr/>
            </p:nvSpPr>
            <p:spPr>
              <a:xfrm>
                <a:off x="3605639" y="4823235"/>
                <a:ext cx="82152" cy="27716"/>
              </a:xfrm>
              <a:prstGeom prst="flowChartTerminator">
                <a:avLst/>
              </a:prstGeom>
              <a:solidFill>
                <a:schemeClr val="tx1"/>
              </a:solidFill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8" name="순서도: 연결자 47"/>
              <p:cNvSpPr/>
              <p:nvPr/>
            </p:nvSpPr>
            <p:spPr>
              <a:xfrm>
                <a:off x="3446933" y="4783905"/>
                <a:ext cx="27384" cy="27716"/>
              </a:xfrm>
              <a:prstGeom prst="flowChartConnector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9" name="순서도: 수행의 시작/종료 48"/>
              <p:cNvSpPr/>
              <p:nvPr/>
            </p:nvSpPr>
            <p:spPr>
              <a:xfrm>
                <a:off x="3605639" y="4855101"/>
                <a:ext cx="82152" cy="27716"/>
              </a:xfrm>
              <a:prstGeom prst="flowChartTerminator">
                <a:avLst/>
              </a:prstGeom>
              <a:solidFill>
                <a:schemeClr val="tx1"/>
              </a:solidFill>
              <a:ln w="1270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cxnSp>
          <p:nvCxnSpPr>
            <p:cNvPr id="38" name="직선 화살표 연결선 37"/>
            <p:cNvCxnSpPr/>
            <p:nvPr/>
          </p:nvCxnSpPr>
          <p:spPr>
            <a:xfrm>
              <a:off x="2331000" y="4053260"/>
              <a:ext cx="3276000" cy="0"/>
            </a:xfrm>
            <a:prstGeom prst="straightConnector1">
              <a:avLst/>
            </a:prstGeom>
            <a:ln w="22225">
              <a:solidFill>
                <a:schemeClr val="tx1">
                  <a:lumMod val="85000"/>
                  <a:lumOff val="15000"/>
                </a:schemeClr>
              </a:solidFill>
              <a:prstDash val="solid"/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/>
            <p:cNvSpPr txBox="1"/>
            <p:nvPr/>
          </p:nvSpPr>
          <p:spPr>
            <a:xfrm>
              <a:off x="2808000" y="3090260"/>
              <a:ext cx="1296000" cy="83099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Histology</a:t>
              </a:r>
              <a:r>
                <a:rPr lang="en-US" altLang="ko-KR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, </a:t>
              </a:r>
              <a:endParaRPr lang="en-US" altLang="ko-KR" sz="1200" b="1" dirty="0" smtClean="0">
                <a:latin typeface="Calibri" panose="020F0502020204030204" pitchFamily="34" charset="0"/>
                <a:cs typeface="Calibri" panose="020F0502020204030204" pitchFamily="34" charset="0"/>
              </a:endParaRPr>
            </a:p>
            <a:p>
              <a:pPr algn="ctr"/>
              <a:r>
                <a:rPr lang="en-US" altLang="ko-KR" sz="1200" b="1" smtClean="0">
                  <a:latin typeface="Calibri" panose="020F0502020204030204" pitchFamily="34" charset="0"/>
                  <a:cs typeface="Calibri" panose="020F0502020204030204" pitchFamily="34" charset="0"/>
                </a:rPr>
                <a:t>Flow cytometry</a:t>
              </a:r>
              <a:r>
                <a:rPr lang="en-US" altLang="ko-KR" sz="12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, </a:t>
              </a:r>
            </a:p>
            <a:p>
              <a:pPr algn="ctr"/>
              <a:r>
                <a:rPr lang="en-US" altLang="ko-KR" sz="1200" b="1" dirty="0" smtClean="0">
                  <a:latin typeface="Calibri" panose="020F0502020204030204" pitchFamily="34" charset="0"/>
                  <a:cs typeface="Calibri" panose="020F0502020204030204" pitchFamily="34" charset="0"/>
                </a:rPr>
                <a:t>Gut </a:t>
              </a:r>
              <a:r>
                <a:rPr lang="en-US" altLang="ko-KR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permeability </a:t>
              </a:r>
            </a:p>
            <a:p>
              <a:pPr algn="ctr"/>
              <a:endParaRPr lang="ko-KR" altLang="en-US" sz="1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968000" y="3276595"/>
              <a:ext cx="129600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Termination of experiment 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1820378" y="4797000"/>
              <a:ext cx="453362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Calibri" panose="020F0502020204030204" pitchFamily="34" charset="0"/>
                  <a:ea typeface="Arial Unicode MS" panose="020B0604020202020204" pitchFamily="50" charset="-127"/>
                  <a:cs typeface="Calibri" panose="020F0502020204030204" pitchFamily="34" charset="0"/>
                </a:rPr>
                <a:t> </a:t>
              </a:r>
              <a:r>
                <a:rPr lang="en-US" altLang="ko-KR" sz="1200" b="1" dirty="0" smtClean="0">
                  <a:latin typeface="Calibri" panose="020F0502020204030204" pitchFamily="34" charset="0"/>
                  <a:ea typeface="Arial Unicode MS" panose="020B0604020202020204" pitchFamily="50" charset="-127"/>
                  <a:cs typeface="Calibri" panose="020F0502020204030204" pitchFamily="34" charset="0"/>
                </a:rPr>
                <a:t>0        4                            16                                                         40  </a:t>
              </a:r>
              <a:r>
                <a:rPr lang="en-US" altLang="ko-KR" sz="1200" b="1" dirty="0" err="1" smtClean="0">
                  <a:latin typeface="Calibri" panose="020F0502020204030204" pitchFamily="34" charset="0"/>
                  <a:ea typeface="Arial Unicode MS" panose="020B0604020202020204" pitchFamily="50" charset="-127"/>
                  <a:cs typeface="Calibri" panose="020F0502020204030204" pitchFamily="34" charset="0"/>
                </a:rPr>
                <a:t>wk</a:t>
              </a:r>
              <a:endParaRPr lang="ko-KR" altLang="en-US" sz="1200" b="1" dirty="0">
                <a:latin typeface="Calibri" panose="020F0502020204030204" pitchFamily="34" charset="0"/>
                <a:ea typeface="Arial Unicode MS" panose="020B0604020202020204" pitchFamily="50" charset="-127"/>
                <a:cs typeface="Calibri" panose="020F0502020204030204" pitchFamily="34" charset="0"/>
              </a:endParaRPr>
            </a:p>
          </p:txBody>
        </p:sp>
        <p:cxnSp>
          <p:nvCxnSpPr>
            <p:cNvPr id="42" name="직선 연결선 41"/>
            <p:cNvCxnSpPr/>
            <p:nvPr/>
          </p:nvCxnSpPr>
          <p:spPr>
            <a:xfrm>
              <a:off x="1989000" y="5112000"/>
              <a:ext cx="0" cy="360000"/>
            </a:xfrm>
            <a:prstGeom prst="line">
              <a:avLst/>
            </a:prstGeom>
            <a:ln w="25400" cmpd="sng">
              <a:prstDash val="soli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926122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직사각형 98"/>
          <p:cNvSpPr/>
          <p:nvPr/>
        </p:nvSpPr>
        <p:spPr>
          <a:xfrm>
            <a:off x="496479" y="7182674"/>
            <a:ext cx="5865043" cy="3361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endParaRPr lang="ko-KR" altLang="ko-KR" sz="1200" dirty="0">
              <a:latin typeface="Times New Roman" panose="02020603050405020304" pitchFamily="18" charset="0"/>
              <a:ea typeface="Arial Unicode MS" panose="020B06040202020202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83" name="직사각형 82"/>
          <p:cNvSpPr/>
          <p:nvPr/>
        </p:nvSpPr>
        <p:spPr>
          <a:xfrm>
            <a:off x="401168" y="6957000"/>
            <a:ext cx="6055664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Figure S2</a:t>
            </a:r>
            <a:r>
              <a:rPr lang="en-US" altLang="ko-KR" sz="1200" b="1" dirty="0"/>
              <a:t>|</a:t>
            </a:r>
            <a:r>
              <a:rPr lang="en-US" altLang="ko-KR" sz="1200" b="1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dirty="0" err="1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Diabetogenic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 T cell priming in NOD mice treated with IRT5. In vivo proliferation of naïve BDC2.5 CD4</a:t>
            </a:r>
            <a:r>
              <a:rPr lang="en-US" altLang="ko-KR" sz="1200" baseline="300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 T cells in </a:t>
            </a:r>
            <a:r>
              <a:rPr lang="en-US" altLang="ko-KR" sz="1200" dirty="0" smtClean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pancreatic 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lymph nodes (PLNs) after adoptive transfer to NOD mice treated with IRT5 for 12 </a:t>
            </a:r>
            <a:r>
              <a:rPr lang="en-US" altLang="ko-KR" sz="1200" dirty="0" smtClean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weeks or control 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NOD mice. Histogram showing BDC2.5 CD4</a:t>
            </a:r>
            <a:r>
              <a:rPr lang="en-US" altLang="ko-KR" sz="1200" baseline="300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 T cell proliferation assessed by CFSE dilution in CD4</a:t>
            </a:r>
            <a:r>
              <a:rPr lang="en-US" altLang="ko-KR" sz="1200" baseline="300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V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  <a:sym typeface="Symbol"/>
              </a:rPr>
              <a:t>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4</a:t>
            </a:r>
            <a:r>
              <a:rPr lang="en-US" altLang="ko-KR" sz="1200" baseline="300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 cells in the spleen (SP), </a:t>
            </a:r>
            <a:r>
              <a:rPr lang="en-US" altLang="ko-KR" sz="1200" dirty="0" smtClean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mesenteric lymph nodes (MLNs) 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or PLNs (left). A graph showing the proliferation index of transferred BDC2.5 CD4</a:t>
            </a:r>
            <a:r>
              <a:rPr lang="en-US" altLang="ko-KR" sz="1200" baseline="300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 T cells in PLNs is shown (right) (</a:t>
            </a:r>
            <a:r>
              <a:rPr lang="en-US" altLang="ko-KR" sz="1200" i="1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n</a:t>
            </a:r>
            <a:r>
              <a:rPr lang="en-US" altLang="ko-KR" sz="1200" dirty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 = 7 for NOD-PBS and 7 for NOD-IRT5). (ns, not significant</a:t>
            </a:r>
            <a:r>
              <a:rPr lang="en-US" altLang="ko-KR" sz="1200" dirty="0" smtClean="0">
                <a:latin typeface="Times New Roman" panose="02020603050405020304" pitchFamily="18" charset="0"/>
                <a:ea typeface="Adobe Ming Std L" pitchFamily="18" charset="-128"/>
                <a:cs typeface="Times New Roman" panose="02020603050405020304" pitchFamily="18" charset="0"/>
              </a:rPr>
              <a:t>)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5" name="그룹 84"/>
          <p:cNvGrpSpPr/>
          <p:nvPr/>
        </p:nvGrpSpPr>
        <p:grpSpPr>
          <a:xfrm>
            <a:off x="1492616" y="2812565"/>
            <a:ext cx="3873134" cy="3518871"/>
            <a:chOff x="4093201" y="1451609"/>
            <a:chExt cx="3873134" cy="3518871"/>
          </a:xfrm>
        </p:grpSpPr>
        <p:graphicFrame>
          <p:nvGraphicFramePr>
            <p:cNvPr id="90" name="개체 8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937777523"/>
                </p:ext>
              </p:extLst>
            </p:nvPr>
          </p:nvGraphicFramePr>
          <p:xfrm>
            <a:off x="6609023" y="2793532"/>
            <a:ext cx="1357312" cy="207486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2080" name="Prism Project" r:id="rId4" imgW="2268000" imgH="3456000" progId="Prism5.Document">
                    <p:embed/>
                  </p:oleObj>
                </mc:Choice>
                <mc:Fallback>
                  <p:oleObj name="Prism Project" r:id="rId4" imgW="2268000" imgH="3456000" progId="Prism5.Document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6609023" y="2793532"/>
                          <a:ext cx="1357312" cy="2074862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97" name="그룹 96"/>
            <p:cNvGrpSpPr/>
            <p:nvPr/>
          </p:nvGrpSpPr>
          <p:grpSpPr>
            <a:xfrm>
              <a:off x="4093201" y="1451609"/>
              <a:ext cx="2513496" cy="3518871"/>
              <a:chOff x="4093201" y="1451609"/>
              <a:chExt cx="2513496" cy="3518871"/>
            </a:xfrm>
          </p:grpSpPr>
          <p:sp>
            <p:nvSpPr>
              <p:cNvPr id="108" name="TextBox 107"/>
              <p:cNvSpPr txBox="1"/>
              <p:nvPr/>
            </p:nvSpPr>
            <p:spPr bwMode="auto">
              <a:xfrm>
                <a:off x="4881545" y="4716564"/>
                <a:ext cx="1725152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Gated on CD4</a:t>
                </a:r>
                <a:r>
                  <a:rPr lang="en-US" altLang="ko-KR" sz="1050" baseline="30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+</a:t>
                </a:r>
                <a:r>
                  <a:rPr lang="en-US" altLang="ko-KR" sz="105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/V</a:t>
                </a:r>
                <a:r>
                  <a:rPr lang="en-US" altLang="ko-KR" sz="1050" dirty="0" smtClean="0">
                    <a:latin typeface="Symbol" pitchFamily="18" charset="2"/>
                    <a:ea typeface="Arial Unicode MS" pitchFamily="50" charset="-127"/>
                    <a:cs typeface="Arial Unicode MS" pitchFamily="50" charset="-127"/>
                  </a:rPr>
                  <a:t>b</a:t>
                </a:r>
                <a:r>
                  <a:rPr lang="en-US" altLang="ko-KR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4</a:t>
                </a:r>
                <a:r>
                  <a:rPr lang="en-US" altLang="ko-KR" sz="1050" baseline="30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+</a:t>
                </a:r>
                <a:r>
                  <a:rPr lang="en-US" altLang="ko-KR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 cells</a:t>
                </a:r>
                <a:endParaRPr lang="ko-KR" altLang="en-US" sz="1050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pic>
            <p:nvPicPr>
              <p:cNvPr id="109" name="Picture 2"/>
              <p:cNvPicPr>
                <a:picLocks noChangeAspect="1" noChangeArrowheads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58678" y="3599634"/>
                <a:ext cx="1879130" cy="93956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0" name="TextBox 37"/>
              <p:cNvSpPr txBox="1">
                <a:spLocks noChangeArrowheads="1"/>
              </p:cNvSpPr>
              <p:nvPr/>
            </p:nvSpPr>
            <p:spPr bwMode="auto">
              <a:xfrm rot="16200000">
                <a:off x="4146193" y="3962990"/>
                <a:ext cx="864000" cy="2539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ctr" eaLnBrk="1" hangingPunct="1"/>
                <a:r>
                  <a:rPr lang="en-US" altLang="en-US" sz="105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ount</a:t>
                </a:r>
              </a:p>
            </p:txBody>
          </p:sp>
          <p:sp>
            <p:nvSpPr>
              <p:cNvPr id="111" name="Text Box 30"/>
              <p:cNvSpPr txBox="1">
                <a:spLocks noChangeArrowheads="1"/>
              </p:cNvSpPr>
              <p:nvPr/>
            </p:nvSpPr>
            <p:spPr bwMode="auto">
              <a:xfrm>
                <a:off x="5306901" y="4513984"/>
                <a:ext cx="576000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anchor="ctr">
                <a:spAutoFit/>
              </a:bodyPr>
              <a:lstStyle/>
              <a:p>
                <a:pPr algn="ctr"/>
                <a:r>
                  <a:rPr lang="en-US" altLang="ko-KR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FSE</a:t>
                </a:r>
                <a:endParaRPr lang="en-US" altLang="ko-KR" sz="800" dirty="0">
                  <a:latin typeface="Symbol" pitchFamily="18" charset="2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cxnSp>
            <p:nvCxnSpPr>
              <p:cNvPr id="112" name="직선 연결선 111"/>
              <p:cNvCxnSpPr/>
              <p:nvPr/>
            </p:nvCxnSpPr>
            <p:spPr>
              <a:xfrm>
                <a:off x="5848751" y="4636046"/>
                <a:ext cx="648000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13" name="직선 연결선 112"/>
              <p:cNvCxnSpPr/>
              <p:nvPr/>
            </p:nvCxnSpPr>
            <p:spPr>
              <a:xfrm>
                <a:off x="4671009" y="4636046"/>
                <a:ext cx="648000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4" name="TextBox 113"/>
              <p:cNvSpPr txBox="1"/>
              <p:nvPr/>
            </p:nvSpPr>
            <p:spPr bwMode="auto">
              <a:xfrm>
                <a:off x="4692618" y="3831537"/>
                <a:ext cx="7200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37.3%</a:t>
                </a:r>
                <a:endParaRPr lang="ko-KR" altLang="en-US" sz="1000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 bwMode="auto">
              <a:xfrm>
                <a:off x="5661601" y="3836985"/>
                <a:ext cx="7200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39.7%</a:t>
                </a:r>
                <a:endParaRPr lang="ko-KR" altLang="en-US" sz="1000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pic>
            <p:nvPicPr>
              <p:cNvPr id="116" name="Picture 279"/>
              <p:cNvPicPr>
                <a:picLocks noChangeAspect="1" noChangeArrowheads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554" t="8616" r="12595" b="19529"/>
              <a:stretch/>
            </p:blipFill>
            <p:spPr bwMode="auto">
              <a:xfrm>
                <a:off x="4696740" y="1672301"/>
                <a:ext cx="896625" cy="91578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17" name="Picture 280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029" t="8883" r="4179" b="18803"/>
              <a:stretch/>
            </p:blipFill>
            <p:spPr bwMode="auto">
              <a:xfrm>
                <a:off x="5623536" y="1671467"/>
                <a:ext cx="929831" cy="9209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8" name="TextBox 117"/>
              <p:cNvSpPr txBox="1"/>
              <p:nvPr/>
            </p:nvSpPr>
            <p:spPr bwMode="auto">
              <a:xfrm>
                <a:off x="4705783" y="2018414"/>
                <a:ext cx="7200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17.2%</a:t>
                </a:r>
                <a:endParaRPr lang="ko-KR" altLang="en-US" sz="1000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 bwMode="auto">
              <a:xfrm>
                <a:off x="5674766" y="2012960"/>
                <a:ext cx="720000" cy="24622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16.5%</a:t>
                </a:r>
                <a:endParaRPr lang="ko-KR" altLang="en-US" sz="1000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20" name="TextBox 37"/>
              <p:cNvSpPr txBox="1">
                <a:spLocks noChangeArrowheads="1"/>
              </p:cNvSpPr>
              <p:nvPr/>
            </p:nvSpPr>
            <p:spPr bwMode="auto">
              <a:xfrm rot="16200000">
                <a:off x="4146193" y="2027635"/>
                <a:ext cx="864000" cy="2539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ctr" eaLnBrk="1" hangingPunct="1"/>
                <a:r>
                  <a:rPr lang="en-US" altLang="en-US" sz="105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ount</a:t>
                </a:r>
                <a:endParaRPr lang="en-US" altLang="en-US" sz="8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21" name="TextBox 120"/>
              <p:cNvSpPr txBox="1"/>
              <p:nvPr/>
            </p:nvSpPr>
            <p:spPr bwMode="auto">
              <a:xfrm>
                <a:off x="4111201" y="3641656"/>
                <a:ext cx="432000" cy="864000"/>
              </a:xfrm>
              <a:prstGeom prst="rect">
                <a:avLst/>
              </a:prstGeom>
              <a:noFill/>
            </p:spPr>
            <p:txBody>
              <a:bodyPr anchor="ctr">
                <a:spAutoFit/>
              </a:bodyPr>
              <a:lstStyle/>
              <a:p>
                <a:pPr algn="ctr">
                  <a:defRPr/>
                </a:pPr>
                <a:r>
                  <a:rPr lang="en-US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P</a:t>
                </a:r>
                <a:r>
                  <a:rPr lang="en-US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LN</a:t>
                </a:r>
                <a:endParaRPr lang="en-US" sz="10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22" name="TextBox 121"/>
              <p:cNvSpPr txBox="1"/>
              <p:nvPr/>
            </p:nvSpPr>
            <p:spPr bwMode="auto">
              <a:xfrm>
                <a:off x="4147201" y="1723553"/>
                <a:ext cx="360000" cy="828000"/>
              </a:xfrm>
              <a:prstGeom prst="rect">
                <a:avLst/>
              </a:prstGeom>
              <a:noFill/>
            </p:spPr>
            <p:txBody>
              <a:bodyPr anchor="ctr">
                <a:spAutoFit/>
              </a:bodyPr>
              <a:lstStyle/>
              <a:p>
                <a:pPr algn="ctr">
                  <a:defRPr/>
                </a:pPr>
                <a:r>
                  <a:rPr lang="en-US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SP</a:t>
                </a:r>
                <a:endParaRPr lang="en-US" sz="10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pic>
            <p:nvPicPr>
              <p:cNvPr id="123" name="Picture 8"/>
              <p:cNvPicPr>
                <a:picLocks noChangeAspect="1" noChangeArrowheads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681" t="7973" r="9315" b="23366"/>
              <a:stretch/>
            </p:blipFill>
            <p:spPr bwMode="auto">
              <a:xfrm>
                <a:off x="4694850" y="2601810"/>
                <a:ext cx="894741" cy="9117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124" name="Picture 9"/>
              <p:cNvPicPr>
                <a:picLocks noChangeAspect="1" noChangeArrowheads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653" t="8579" r="2745" b="21736"/>
              <a:stretch/>
            </p:blipFill>
            <p:spPr bwMode="auto">
              <a:xfrm>
                <a:off x="5655511" y="2601810"/>
                <a:ext cx="937493" cy="90902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25" name="TextBox 37"/>
              <p:cNvSpPr txBox="1">
                <a:spLocks noChangeArrowheads="1"/>
              </p:cNvSpPr>
              <p:nvPr/>
            </p:nvSpPr>
            <p:spPr bwMode="auto">
              <a:xfrm rot="16200000">
                <a:off x="4175018" y="2933580"/>
                <a:ext cx="828000" cy="2539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ctr" eaLnBrk="1" hangingPunct="1"/>
                <a:r>
                  <a:rPr lang="en-US" altLang="en-US" sz="105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ount</a:t>
                </a:r>
                <a:endParaRPr lang="en-US" altLang="en-US" sz="8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26" name="TextBox 125"/>
              <p:cNvSpPr txBox="1"/>
              <p:nvPr/>
            </p:nvSpPr>
            <p:spPr bwMode="auto">
              <a:xfrm>
                <a:off x="4093201" y="2637372"/>
                <a:ext cx="504000" cy="828000"/>
              </a:xfrm>
              <a:prstGeom prst="rect">
                <a:avLst/>
              </a:prstGeom>
              <a:noFill/>
            </p:spPr>
            <p:txBody>
              <a:bodyPr anchor="ctr">
                <a:spAutoFit/>
              </a:bodyPr>
              <a:lstStyle/>
              <a:p>
                <a:pPr algn="ctr">
                  <a:defRPr/>
                </a:pPr>
                <a:r>
                  <a:rPr lang="en-US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MLN</a:t>
                </a:r>
                <a:endParaRPr lang="en-US" sz="10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27" name="TextBox 46"/>
              <p:cNvSpPr txBox="1">
                <a:spLocks noChangeArrowheads="1"/>
              </p:cNvSpPr>
              <p:nvPr/>
            </p:nvSpPr>
            <p:spPr bwMode="auto">
              <a:xfrm>
                <a:off x="4708684" y="1451609"/>
                <a:ext cx="864000" cy="2539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anchor="ctr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ctr" eaLnBrk="1" hangingPunct="1"/>
                <a:r>
                  <a:rPr lang="en-US" altLang="en-US" sz="105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D-PBS</a:t>
                </a:r>
              </a:p>
            </p:txBody>
          </p:sp>
          <p:sp>
            <p:nvSpPr>
              <p:cNvPr id="128" name="TextBox 47"/>
              <p:cNvSpPr txBox="1">
                <a:spLocks noChangeArrowheads="1"/>
              </p:cNvSpPr>
              <p:nvPr/>
            </p:nvSpPr>
            <p:spPr bwMode="auto">
              <a:xfrm>
                <a:off x="5692994" y="1451609"/>
                <a:ext cx="828000" cy="25391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anchor="ctr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ctr" eaLnBrk="1" hangingPunct="1"/>
                <a:r>
                  <a:rPr lang="en-US" altLang="en-US" sz="105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D-IRT5</a:t>
                </a:r>
              </a:p>
            </p:txBody>
          </p:sp>
          <p:sp>
            <p:nvSpPr>
              <p:cNvPr id="129" name="직사각형 128"/>
              <p:cNvSpPr/>
              <p:nvPr/>
            </p:nvSpPr>
            <p:spPr>
              <a:xfrm>
                <a:off x="4705782" y="1701264"/>
                <a:ext cx="864000" cy="846000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30" name="직사각형 129"/>
              <p:cNvSpPr/>
              <p:nvPr/>
            </p:nvSpPr>
            <p:spPr>
              <a:xfrm>
                <a:off x="5658774" y="1698348"/>
                <a:ext cx="864000" cy="838800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31" name="직사각형 130"/>
              <p:cNvSpPr/>
              <p:nvPr/>
            </p:nvSpPr>
            <p:spPr>
              <a:xfrm>
                <a:off x="4710777" y="2633655"/>
                <a:ext cx="864000" cy="864000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32" name="직사각형 131"/>
              <p:cNvSpPr/>
              <p:nvPr/>
            </p:nvSpPr>
            <p:spPr>
              <a:xfrm>
                <a:off x="5664000" y="2633107"/>
                <a:ext cx="864000" cy="864000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33" name="직사각형 132"/>
              <p:cNvSpPr/>
              <p:nvPr/>
            </p:nvSpPr>
            <p:spPr>
              <a:xfrm>
                <a:off x="4700934" y="3627167"/>
                <a:ext cx="882000" cy="882000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dirty="0"/>
              </a:p>
            </p:txBody>
          </p:sp>
          <p:sp>
            <p:nvSpPr>
              <p:cNvPr id="134" name="직사각형 133"/>
              <p:cNvSpPr/>
              <p:nvPr/>
            </p:nvSpPr>
            <p:spPr>
              <a:xfrm>
                <a:off x="5650101" y="3622563"/>
                <a:ext cx="882000" cy="882000"/>
              </a:xfrm>
              <a:prstGeom prst="rect">
                <a:avLst/>
              </a:prstGeom>
              <a:noFill/>
              <a:ln w="254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cxnSp>
            <p:nvCxnSpPr>
              <p:cNvPr id="135" name="직선 연결선 134"/>
              <p:cNvCxnSpPr/>
              <p:nvPr/>
            </p:nvCxnSpPr>
            <p:spPr>
              <a:xfrm>
                <a:off x="4718482" y="2246089"/>
                <a:ext cx="648000" cy="1872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직선 연결선 135"/>
              <p:cNvCxnSpPr/>
              <p:nvPr/>
            </p:nvCxnSpPr>
            <p:spPr>
              <a:xfrm>
                <a:off x="5366482" y="2211025"/>
                <a:ext cx="0" cy="72000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직선 연결선 136"/>
              <p:cNvCxnSpPr/>
              <p:nvPr/>
            </p:nvCxnSpPr>
            <p:spPr>
              <a:xfrm>
                <a:off x="5677782" y="2243858"/>
                <a:ext cx="648000" cy="1872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직선 연결선 137"/>
              <p:cNvCxnSpPr/>
              <p:nvPr/>
            </p:nvCxnSpPr>
            <p:spPr>
              <a:xfrm>
                <a:off x="6325782" y="2208794"/>
                <a:ext cx="0" cy="72000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직선 연결선 138"/>
              <p:cNvCxnSpPr/>
              <p:nvPr/>
            </p:nvCxnSpPr>
            <p:spPr>
              <a:xfrm>
                <a:off x="4711050" y="4054753"/>
                <a:ext cx="720000" cy="1872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직선 연결선 139"/>
              <p:cNvCxnSpPr/>
              <p:nvPr/>
            </p:nvCxnSpPr>
            <p:spPr>
              <a:xfrm>
                <a:off x="5435250" y="4019689"/>
                <a:ext cx="0" cy="72000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직선 연결선 140"/>
              <p:cNvCxnSpPr/>
              <p:nvPr/>
            </p:nvCxnSpPr>
            <p:spPr>
              <a:xfrm>
                <a:off x="5664000" y="4052522"/>
                <a:ext cx="702000" cy="1872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직선 연결선 141"/>
              <p:cNvCxnSpPr/>
              <p:nvPr/>
            </p:nvCxnSpPr>
            <p:spPr>
              <a:xfrm>
                <a:off x="6369150" y="4017458"/>
                <a:ext cx="0" cy="72000"/>
              </a:xfrm>
              <a:prstGeom prst="line">
                <a:avLst/>
              </a:prstGeom>
              <a:ln w="2540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16848273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직사각형 98"/>
          <p:cNvSpPr/>
          <p:nvPr/>
        </p:nvSpPr>
        <p:spPr>
          <a:xfrm>
            <a:off x="496479" y="7182674"/>
            <a:ext cx="5865043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ko-KR" sz="1200" b="1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Figure S3</a:t>
            </a:r>
            <a:r>
              <a:rPr lang="en-US" altLang="ko-KR" sz="1200" b="1" dirty="0"/>
              <a:t>|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T cell subset in NOD mice treated with IRT5 for 12 weeks. </a:t>
            </a:r>
            <a:r>
              <a:rPr lang="en-US" altLang="ko-KR" sz="1200" b="1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(A) 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Cells from PLNs, MLNs 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or lamina </a:t>
            </a:r>
            <a:r>
              <a:rPr lang="en-US" altLang="ko-KR" sz="1200" dirty="0" err="1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propria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of small intestine (SI-LP) 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of IRT5-treated and control NOD mice were stained with anti-CD3 </a:t>
            </a:r>
            <a:r>
              <a:rPr lang="en-US" altLang="ko-KR" sz="1200" dirty="0" err="1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mAbs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for 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flow cytometry. The percentages 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of CD3</a:t>
            </a:r>
            <a:r>
              <a:rPr lang="en-US" altLang="ko-KR" sz="1200" baseline="300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cells were compared (right). Representative </a:t>
            </a:r>
            <a:r>
              <a:rPr lang="en-US" altLang="ko-KR" sz="1200" dirty="0" err="1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scattergrams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are shown (left).</a:t>
            </a:r>
            <a:r>
              <a:rPr lang="en-US" altLang="ko-KR" sz="1200" b="1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(B) 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Cells in </a:t>
            </a:r>
            <a:r>
              <a:rPr lang="en-US" altLang="ko-KR" sz="1200" b="1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(A) 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were stained with anti-CD4 and -CD8 </a:t>
            </a:r>
            <a:r>
              <a:rPr lang="en-US" altLang="ko-KR" sz="1200" dirty="0" err="1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mAbs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for </a:t>
            </a:r>
            <a:r>
              <a:rPr lang="en-US" altLang="ko-KR" sz="1200" dirty="0" smtClean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flow 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cytometry. The percentages of CD4</a:t>
            </a:r>
            <a:r>
              <a:rPr lang="en-US" altLang="ko-KR" sz="1200" baseline="300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or CD8</a:t>
            </a:r>
            <a:r>
              <a:rPr lang="en-US" altLang="ko-KR" sz="1200" baseline="300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+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cells were compared (right). Representative </a:t>
            </a:r>
            <a:r>
              <a:rPr lang="en-US" altLang="ko-KR" sz="1200" dirty="0" err="1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scattergrams</a:t>
            </a:r>
            <a:r>
              <a:rPr lang="en-US" altLang="ko-KR" sz="1200" dirty="0">
                <a:latin typeface="Times New Roman" panose="02020603050405020304" pitchFamily="18" charset="0"/>
                <a:ea typeface="Arial Unicode MS" panose="020B0604020202020204" pitchFamily="50" charset="-127"/>
                <a:cs typeface="Times New Roman" panose="02020603050405020304" pitchFamily="18" charset="0"/>
              </a:rPr>
              <a:t> are shown (left).</a:t>
            </a:r>
            <a:endParaRPr lang="ko-KR" altLang="ko-KR" sz="1200" dirty="0">
              <a:latin typeface="Times New Roman" panose="02020603050405020304" pitchFamily="18" charset="0"/>
              <a:ea typeface="Arial Unicode MS" panose="020B0604020202020204" pitchFamily="50" charset="-127"/>
              <a:cs typeface="Times New Roman" panose="02020603050405020304" pitchFamily="18" charset="0"/>
            </a:endParaRPr>
          </a:p>
        </p:txBody>
      </p:sp>
      <p:grpSp>
        <p:nvGrpSpPr>
          <p:cNvPr id="107" name="그룹 106"/>
          <p:cNvGrpSpPr/>
          <p:nvPr/>
        </p:nvGrpSpPr>
        <p:grpSpPr>
          <a:xfrm>
            <a:off x="234000" y="125496"/>
            <a:ext cx="6214425" cy="7100804"/>
            <a:chOff x="157871" y="35496"/>
            <a:chExt cx="6214425" cy="7100804"/>
          </a:xfrm>
        </p:grpSpPr>
        <p:grpSp>
          <p:nvGrpSpPr>
            <p:cNvPr id="106" name="그룹 105"/>
            <p:cNvGrpSpPr/>
            <p:nvPr/>
          </p:nvGrpSpPr>
          <p:grpSpPr>
            <a:xfrm>
              <a:off x="157871" y="3373084"/>
              <a:ext cx="6214425" cy="3763216"/>
              <a:chOff x="157871" y="3373084"/>
              <a:chExt cx="6214425" cy="3763216"/>
            </a:xfrm>
          </p:grpSpPr>
          <p:sp>
            <p:nvSpPr>
              <p:cNvPr id="18" name="TextBox 17"/>
              <p:cNvSpPr txBox="1"/>
              <p:nvPr/>
            </p:nvSpPr>
            <p:spPr bwMode="auto">
              <a:xfrm>
                <a:off x="3892871" y="3373084"/>
                <a:ext cx="2448000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ko-KR" altLang="en-US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□ </a:t>
                </a:r>
                <a:r>
                  <a:rPr lang="en-US" altLang="ko-KR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D-PBS </a:t>
                </a:r>
                <a:r>
                  <a:rPr lang="ko-KR" altLang="en-US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■ </a:t>
                </a:r>
                <a:r>
                  <a:rPr lang="en-US" altLang="ko-KR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D-IRT5</a:t>
                </a:r>
                <a:endParaRPr lang="ko-KR" altLang="en-US" sz="105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9" name="직사각형 11"/>
              <p:cNvSpPr>
                <a:spLocks noChangeArrowheads="1"/>
              </p:cNvSpPr>
              <p:nvPr/>
            </p:nvSpPr>
            <p:spPr bwMode="auto">
              <a:xfrm>
                <a:off x="157871" y="3452107"/>
                <a:ext cx="28725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ko-KR" sz="12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B</a:t>
                </a:r>
                <a:endParaRPr lang="ko-KR" altLang="en-US" sz="12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8" name="TextBox 46"/>
              <p:cNvSpPr txBox="1">
                <a:spLocks noChangeArrowheads="1"/>
              </p:cNvSpPr>
              <p:nvPr/>
            </p:nvSpPr>
            <p:spPr bwMode="auto">
              <a:xfrm>
                <a:off x="1012871" y="3537000"/>
                <a:ext cx="1123379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anchor="ctr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ctr" eaLnBrk="1" hangingPunct="1"/>
                <a:r>
                  <a:rPr lang="en-US" altLang="en-US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D-PBS</a:t>
                </a:r>
              </a:p>
            </p:txBody>
          </p:sp>
          <p:sp>
            <p:nvSpPr>
              <p:cNvPr id="49" name="TextBox 47"/>
              <p:cNvSpPr txBox="1">
                <a:spLocks noChangeArrowheads="1"/>
              </p:cNvSpPr>
              <p:nvPr/>
            </p:nvSpPr>
            <p:spPr bwMode="auto">
              <a:xfrm>
                <a:off x="2158831" y="3537000"/>
                <a:ext cx="110404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anchor="ctr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ctr" eaLnBrk="1" hangingPunct="1"/>
                <a:r>
                  <a:rPr lang="en-US" altLang="en-US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D-IRT5</a:t>
                </a:r>
              </a:p>
            </p:txBody>
          </p:sp>
          <p:sp>
            <p:nvSpPr>
              <p:cNvPr id="50" name="TextBox 5"/>
              <p:cNvSpPr txBox="1">
                <a:spLocks noChangeArrowheads="1"/>
              </p:cNvSpPr>
              <p:nvPr/>
            </p:nvSpPr>
            <p:spPr bwMode="auto">
              <a:xfrm>
                <a:off x="1102871" y="6668774"/>
                <a:ext cx="219946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r" eaLnBrk="1" hangingPunct="1"/>
                <a:r>
                  <a:rPr lang="en-US" altLang="ko-KR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Gated </a:t>
                </a:r>
                <a:r>
                  <a:rPr lang="en-US" altLang="ko-KR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on CD3</a:t>
                </a:r>
                <a:r>
                  <a:rPr lang="en-US" altLang="ko-KR" sz="1000" baseline="30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+</a:t>
                </a:r>
                <a:r>
                  <a:rPr lang="en-US" altLang="ko-KR" sz="1000" baseline="30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 </a:t>
                </a:r>
                <a:r>
                  <a:rPr lang="en-US" altLang="ko-KR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ells</a:t>
                </a:r>
              </a:p>
            </p:txBody>
          </p:sp>
          <p:sp>
            <p:nvSpPr>
              <p:cNvPr id="51" name="Text Box 30"/>
              <p:cNvSpPr txBox="1">
                <a:spLocks noChangeArrowheads="1"/>
              </p:cNvSpPr>
              <p:nvPr/>
            </p:nvSpPr>
            <p:spPr bwMode="auto">
              <a:xfrm>
                <a:off x="1939871" y="6433085"/>
                <a:ext cx="468000" cy="26161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anchor="ctr">
                <a:spAutoFit/>
              </a:bodyPr>
              <a:lstStyle/>
              <a:p>
                <a:pPr algn="ctr"/>
                <a:r>
                  <a:rPr lang="en-US" altLang="ko-KR" sz="1100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CD</a:t>
                </a:r>
                <a:r>
                  <a:rPr lang="en-US" altLang="ko-KR" sz="1100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4</a:t>
                </a:r>
              </a:p>
            </p:txBody>
          </p:sp>
          <p:cxnSp>
            <p:nvCxnSpPr>
              <p:cNvPr id="52" name="직선 연결선 51"/>
              <p:cNvCxnSpPr/>
              <p:nvPr/>
            </p:nvCxnSpPr>
            <p:spPr>
              <a:xfrm rot="5400000" flipH="1" flipV="1">
                <a:off x="329327" y="5862190"/>
                <a:ext cx="1008000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53" name="Text Box 30"/>
              <p:cNvSpPr txBox="1">
                <a:spLocks noChangeArrowheads="1"/>
              </p:cNvSpPr>
              <p:nvPr/>
            </p:nvSpPr>
            <p:spPr bwMode="auto">
              <a:xfrm rot="16200000">
                <a:off x="603102" y="4989469"/>
                <a:ext cx="455574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ko-KR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D8</a:t>
                </a:r>
                <a:endParaRPr lang="en-US" altLang="ko-KR" sz="1050" baseline="300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cxnSp>
            <p:nvCxnSpPr>
              <p:cNvPr id="54" name="직선 연결선 53"/>
              <p:cNvCxnSpPr/>
              <p:nvPr/>
            </p:nvCxnSpPr>
            <p:spPr>
              <a:xfrm rot="5400000" flipH="1" flipV="1">
                <a:off x="323358" y="4339357"/>
                <a:ext cx="1008000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직선 연결선 54"/>
              <p:cNvCxnSpPr/>
              <p:nvPr/>
            </p:nvCxnSpPr>
            <p:spPr>
              <a:xfrm>
                <a:off x="2394000" y="6553886"/>
                <a:ext cx="804393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직선 연결선 55"/>
              <p:cNvCxnSpPr/>
              <p:nvPr/>
            </p:nvCxnSpPr>
            <p:spPr>
              <a:xfrm>
                <a:off x="1049918" y="6553886"/>
                <a:ext cx="849082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aphicFrame>
            <p:nvGraphicFramePr>
              <p:cNvPr id="70" name="개체 69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1992536840"/>
                  </p:ext>
                </p:extLst>
              </p:nvPr>
            </p:nvGraphicFramePr>
            <p:xfrm>
              <a:off x="3262384" y="3481875"/>
              <a:ext cx="3005137" cy="19843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320" name="Prism Project" r:id="rId4" imgW="3600000" imgH="2808000" progId="Prism5.Document">
                      <p:embed/>
                    </p:oleObj>
                  </mc:Choice>
                  <mc:Fallback>
                    <p:oleObj name="Prism Project" r:id="rId4" imgW="3600000" imgH="2808000" progId="Prism5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5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262384" y="3481875"/>
                            <a:ext cx="3005137" cy="198437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/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71" name="개체 70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2487307827"/>
                  </p:ext>
                </p:extLst>
              </p:nvPr>
            </p:nvGraphicFramePr>
            <p:xfrm>
              <a:off x="3278259" y="5113825"/>
              <a:ext cx="3094037" cy="20224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321" name="Prism Project" r:id="rId6" imgW="3564000" imgH="2736000" progId="Prism5.Document">
                      <p:embed/>
                    </p:oleObj>
                  </mc:Choice>
                  <mc:Fallback>
                    <p:oleObj name="Prism Project" r:id="rId6" imgW="3564000" imgH="2736000" progId="Prism5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7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278259" y="5113825"/>
                            <a:ext cx="3094037" cy="202247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/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2" name="TextBox 71"/>
              <p:cNvSpPr txBox="1"/>
              <p:nvPr/>
            </p:nvSpPr>
            <p:spPr bwMode="auto">
              <a:xfrm>
                <a:off x="279000" y="4082607"/>
                <a:ext cx="468000" cy="246221"/>
              </a:xfrm>
              <a:prstGeom prst="rect">
                <a:avLst/>
              </a:prstGeom>
              <a:noFill/>
            </p:spPr>
            <p:txBody>
              <a:bodyPr anchor="ctr">
                <a:spAutoFit/>
              </a:bodyPr>
              <a:lstStyle/>
              <a:p>
                <a:pPr algn="ctr">
                  <a:defRPr/>
                </a:pPr>
                <a:r>
                  <a:rPr lang="en-US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P</a:t>
                </a:r>
                <a:r>
                  <a:rPr lang="en-US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LN</a:t>
                </a:r>
                <a:endParaRPr lang="en-US" sz="10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73" name="TextBox 72"/>
              <p:cNvSpPr txBox="1"/>
              <p:nvPr/>
            </p:nvSpPr>
            <p:spPr bwMode="auto">
              <a:xfrm>
                <a:off x="279000" y="4973286"/>
                <a:ext cx="468000" cy="246221"/>
              </a:xfrm>
              <a:prstGeom prst="rect">
                <a:avLst/>
              </a:prstGeom>
              <a:noFill/>
            </p:spPr>
            <p:txBody>
              <a:bodyPr anchor="ctr">
                <a:spAutoFit/>
              </a:bodyPr>
              <a:lstStyle/>
              <a:p>
                <a:pPr algn="ctr">
                  <a:defRPr/>
                </a:pPr>
                <a:r>
                  <a:rPr lang="en-US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MLN</a:t>
                </a:r>
                <a:endParaRPr lang="en-US" sz="10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74" name="TextBox 73"/>
              <p:cNvSpPr txBox="1"/>
              <p:nvPr/>
            </p:nvSpPr>
            <p:spPr bwMode="auto">
              <a:xfrm>
                <a:off x="279000" y="5801120"/>
                <a:ext cx="504000" cy="400110"/>
              </a:xfrm>
              <a:prstGeom prst="rect">
                <a:avLst/>
              </a:prstGeom>
              <a:noFill/>
            </p:spPr>
            <p:txBody>
              <a:bodyPr anchor="ctr">
                <a:spAutoFit/>
              </a:bodyPr>
              <a:lstStyle/>
              <a:p>
                <a:pPr algn="ctr">
                  <a:defRPr/>
                </a:pPr>
                <a:r>
                  <a:rPr lang="en-US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SI-LP</a:t>
                </a:r>
              </a:p>
            </p:txBody>
          </p:sp>
          <p:grpSp>
            <p:nvGrpSpPr>
              <p:cNvPr id="3" name="그룹 2"/>
              <p:cNvGrpSpPr/>
              <p:nvPr/>
            </p:nvGrpSpPr>
            <p:grpSpPr>
              <a:xfrm>
                <a:off x="953994" y="3764050"/>
                <a:ext cx="2371057" cy="883335"/>
                <a:chOff x="953994" y="3764050"/>
                <a:chExt cx="2371057" cy="883335"/>
              </a:xfrm>
            </p:grpSpPr>
            <p:pic>
              <p:nvPicPr>
                <p:cNvPr id="47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33701" b="33149"/>
                <a:stretch/>
              </p:blipFill>
              <p:spPr bwMode="auto">
                <a:xfrm>
                  <a:off x="953994" y="3764050"/>
                  <a:ext cx="2365386" cy="8833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58" name="TextBox 57"/>
                <p:cNvSpPr txBox="1"/>
                <p:nvPr/>
              </p:nvSpPr>
              <p:spPr bwMode="auto">
                <a:xfrm>
                  <a:off x="966812" y="4015612"/>
                  <a:ext cx="625639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8.3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59" name="TextBox 58"/>
                <p:cNvSpPr txBox="1"/>
                <p:nvPr/>
              </p:nvSpPr>
              <p:spPr bwMode="auto">
                <a:xfrm>
                  <a:off x="2163162" y="4005985"/>
                  <a:ext cx="625639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8.4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0" name="TextBox 59"/>
                <p:cNvSpPr txBox="1"/>
                <p:nvPr/>
              </p:nvSpPr>
              <p:spPr bwMode="auto">
                <a:xfrm>
                  <a:off x="1537350" y="4141347"/>
                  <a:ext cx="625639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0.1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1" name="TextBox 60"/>
                <p:cNvSpPr txBox="1"/>
                <p:nvPr/>
              </p:nvSpPr>
              <p:spPr bwMode="auto">
                <a:xfrm>
                  <a:off x="2699412" y="4141347"/>
                  <a:ext cx="625639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0..1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84" name="직사각형 83"/>
                <p:cNvSpPr/>
                <p:nvPr/>
              </p:nvSpPr>
              <p:spPr>
                <a:xfrm>
                  <a:off x="996872" y="3767880"/>
                  <a:ext cx="1116000" cy="86400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1" name="직사각형 90"/>
                <p:cNvSpPr/>
                <p:nvPr/>
              </p:nvSpPr>
              <p:spPr>
                <a:xfrm>
                  <a:off x="2150328" y="3767880"/>
                  <a:ext cx="1116000" cy="86400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grpSp>
            <p:nvGrpSpPr>
              <p:cNvPr id="4" name="그룹 3"/>
              <p:cNvGrpSpPr/>
              <p:nvPr/>
            </p:nvGrpSpPr>
            <p:grpSpPr>
              <a:xfrm>
                <a:off x="944488" y="4647386"/>
                <a:ext cx="2365386" cy="898021"/>
                <a:chOff x="944488" y="4647386"/>
                <a:chExt cx="2365386" cy="898021"/>
              </a:xfrm>
            </p:grpSpPr>
            <p:pic>
              <p:nvPicPr>
                <p:cNvPr id="57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66299"/>
                <a:stretch/>
              </p:blipFill>
              <p:spPr bwMode="auto">
                <a:xfrm>
                  <a:off x="944488" y="4647386"/>
                  <a:ext cx="2365386" cy="89802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66" name="TextBox 65"/>
                <p:cNvSpPr txBox="1"/>
                <p:nvPr/>
              </p:nvSpPr>
              <p:spPr bwMode="auto">
                <a:xfrm>
                  <a:off x="979111" y="4897738"/>
                  <a:ext cx="625639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6.2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7" name="TextBox 66"/>
                <p:cNvSpPr txBox="1"/>
                <p:nvPr/>
              </p:nvSpPr>
              <p:spPr bwMode="auto">
                <a:xfrm>
                  <a:off x="2152899" y="4907536"/>
                  <a:ext cx="625639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8.1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8" name="TextBox 67"/>
                <p:cNvSpPr txBox="1"/>
                <p:nvPr/>
              </p:nvSpPr>
              <p:spPr bwMode="auto">
                <a:xfrm>
                  <a:off x="1631950" y="5031000"/>
                  <a:ext cx="576000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2.0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9" name="TextBox 68"/>
                <p:cNvSpPr txBox="1"/>
                <p:nvPr/>
              </p:nvSpPr>
              <p:spPr bwMode="auto">
                <a:xfrm>
                  <a:off x="2704537" y="5031000"/>
                  <a:ext cx="576000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0.0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92" name="직사각형 91"/>
                <p:cNvSpPr/>
                <p:nvPr/>
              </p:nvSpPr>
              <p:spPr>
                <a:xfrm>
                  <a:off x="992909" y="4674751"/>
                  <a:ext cx="1116000" cy="86400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3" name="직사각형 92"/>
                <p:cNvSpPr/>
                <p:nvPr/>
              </p:nvSpPr>
              <p:spPr>
                <a:xfrm>
                  <a:off x="2154459" y="4674751"/>
                  <a:ext cx="1116000" cy="86400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grpSp>
            <p:nvGrpSpPr>
              <p:cNvPr id="96" name="그룹 95"/>
              <p:cNvGrpSpPr/>
              <p:nvPr/>
            </p:nvGrpSpPr>
            <p:grpSpPr>
              <a:xfrm>
                <a:off x="959118" y="5559508"/>
                <a:ext cx="2365386" cy="883335"/>
                <a:chOff x="959118" y="5559508"/>
                <a:chExt cx="2365386" cy="883335"/>
              </a:xfrm>
            </p:grpSpPr>
            <p:pic>
              <p:nvPicPr>
                <p:cNvPr id="46" name="Picture 2"/>
                <p:cNvPicPr>
                  <a:picLocks noChangeAspect="1" noChangeArrowheads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66851"/>
                <a:stretch/>
              </p:blipFill>
              <p:spPr bwMode="auto">
                <a:xfrm>
                  <a:off x="959118" y="5559508"/>
                  <a:ext cx="2365386" cy="88333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62" name="TextBox 61"/>
                <p:cNvSpPr txBox="1"/>
                <p:nvPr/>
              </p:nvSpPr>
              <p:spPr bwMode="auto">
                <a:xfrm>
                  <a:off x="1006138" y="5797960"/>
                  <a:ext cx="625639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2.0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3" name="TextBox 62"/>
                <p:cNvSpPr txBox="1"/>
                <p:nvPr/>
              </p:nvSpPr>
              <p:spPr bwMode="auto">
                <a:xfrm>
                  <a:off x="2168200" y="5798512"/>
                  <a:ext cx="625639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3.2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4" name="TextBox 63"/>
                <p:cNvSpPr txBox="1"/>
                <p:nvPr/>
              </p:nvSpPr>
              <p:spPr bwMode="auto">
                <a:xfrm>
                  <a:off x="1453361" y="5888256"/>
                  <a:ext cx="576000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6.7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65" name="TextBox 64"/>
                <p:cNvSpPr txBox="1"/>
                <p:nvPr/>
              </p:nvSpPr>
              <p:spPr bwMode="auto">
                <a:xfrm>
                  <a:off x="2615147" y="5888256"/>
                  <a:ext cx="576000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1.4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94" name="직사각형 93"/>
                <p:cNvSpPr/>
                <p:nvPr/>
              </p:nvSpPr>
              <p:spPr>
                <a:xfrm>
                  <a:off x="992909" y="5574997"/>
                  <a:ext cx="1116000" cy="82800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95" name="직사각형 94"/>
                <p:cNvSpPr/>
                <p:nvPr/>
              </p:nvSpPr>
              <p:spPr>
                <a:xfrm>
                  <a:off x="2155327" y="5581570"/>
                  <a:ext cx="1116000" cy="82800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</p:grpSp>
        <p:grpSp>
          <p:nvGrpSpPr>
            <p:cNvPr id="105" name="그룹 104"/>
            <p:cNvGrpSpPr/>
            <p:nvPr/>
          </p:nvGrpSpPr>
          <p:grpSpPr>
            <a:xfrm>
              <a:off x="157871" y="35496"/>
              <a:ext cx="6127113" cy="3266101"/>
              <a:chOff x="157871" y="35496"/>
              <a:chExt cx="6127113" cy="3266101"/>
            </a:xfrm>
          </p:grpSpPr>
          <p:graphicFrame>
            <p:nvGraphicFramePr>
              <p:cNvPr id="38" name="개체 37"/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582741353"/>
                  </p:ext>
                </p:extLst>
              </p:nvPr>
            </p:nvGraphicFramePr>
            <p:xfrm>
              <a:off x="3384621" y="635488"/>
              <a:ext cx="2900363" cy="21129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322" name="Prism Project" r:id="rId9" imgW="3636000" imgH="2808000" progId="Prism5.Document">
                      <p:embed/>
                    </p:oleObj>
                  </mc:Choice>
                  <mc:Fallback>
                    <p:oleObj name="Prism Project" r:id="rId9" imgW="3636000" imgH="2808000" progId="Prism5.Document">
                      <p:embed/>
                      <p:pic>
                        <p:nvPicPr>
                          <p:cNvPr id="0" name=""/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0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384621" y="635488"/>
                            <a:ext cx="2900363" cy="2112962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xtLst/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" name="직사각형 11"/>
              <p:cNvSpPr>
                <a:spLocks noChangeArrowheads="1"/>
              </p:cNvSpPr>
              <p:nvPr/>
            </p:nvSpPr>
            <p:spPr bwMode="auto">
              <a:xfrm>
                <a:off x="157871" y="35496"/>
                <a:ext cx="287258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/>
              <a:p>
                <a:r>
                  <a:rPr lang="en-US" altLang="ko-KR" sz="12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A</a:t>
                </a:r>
                <a:endParaRPr lang="ko-KR" altLang="en-US" sz="12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 bwMode="auto">
              <a:xfrm>
                <a:off x="4018871" y="538084"/>
                <a:ext cx="2124000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ko-KR" altLang="en-US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□ </a:t>
                </a:r>
                <a:r>
                  <a:rPr lang="en-US" altLang="ko-KR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D-PBS </a:t>
                </a:r>
                <a:r>
                  <a:rPr lang="ko-KR" altLang="en-US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■ </a:t>
                </a:r>
                <a:r>
                  <a:rPr lang="en-US" altLang="ko-KR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D-IRT5</a:t>
                </a:r>
                <a:endParaRPr lang="ko-KR" altLang="en-US" sz="105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24" name="Text Box 30"/>
              <p:cNvSpPr txBox="1">
                <a:spLocks noChangeArrowheads="1"/>
              </p:cNvSpPr>
              <p:nvPr/>
            </p:nvSpPr>
            <p:spPr bwMode="auto">
              <a:xfrm rot="16200000">
                <a:off x="687043" y="1562255"/>
                <a:ext cx="455573" cy="25391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pPr algn="ctr"/>
                <a:r>
                  <a:rPr lang="en-US" altLang="ko-KR" sz="105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D3</a:t>
                </a:r>
                <a:endParaRPr lang="en-US" altLang="ko-KR" sz="1000" baseline="300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25" name="TextBox 46"/>
              <p:cNvSpPr txBox="1">
                <a:spLocks noChangeArrowheads="1"/>
              </p:cNvSpPr>
              <p:nvPr/>
            </p:nvSpPr>
            <p:spPr bwMode="auto">
              <a:xfrm>
                <a:off x="1071231" y="155890"/>
                <a:ext cx="1080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anchor="ctr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ctr" eaLnBrk="1" hangingPunct="1"/>
                <a:r>
                  <a:rPr lang="en-US" altLang="en-US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D-PBS</a:t>
                </a:r>
              </a:p>
            </p:txBody>
          </p:sp>
          <p:sp>
            <p:nvSpPr>
              <p:cNvPr id="26" name="TextBox 47"/>
              <p:cNvSpPr txBox="1">
                <a:spLocks noChangeArrowheads="1"/>
              </p:cNvSpPr>
              <p:nvPr/>
            </p:nvSpPr>
            <p:spPr bwMode="auto">
              <a:xfrm>
                <a:off x="2214000" y="155890"/>
                <a:ext cx="108000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anchor="ctr"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ctr" eaLnBrk="1" hangingPunct="1"/>
                <a:r>
                  <a:rPr lang="en-US" altLang="en-US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D-IRT5</a:t>
                </a:r>
              </a:p>
            </p:txBody>
          </p:sp>
          <p:sp>
            <p:nvSpPr>
              <p:cNvPr id="27" name="TextBox 5"/>
              <p:cNvSpPr txBox="1">
                <a:spLocks noChangeArrowheads="1"/>
              </p:cNvSpPr>
              <p:nvPr/>
            </p:nvSpPr>
            <p:spPr bwMode="auto">
              <a:xfrm>
                <a:off x="1153411" y="3055376"/>
                <a:ext cx="2199460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1pPr>
                <a:lvl2pPr marL="742950" indent="-28575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2pPr>
                <a:lvl3pPr marL="11430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3pPr>
                <a:lvl4pPr marL="16002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4pPr>
                <a:lvl5pPr marL="2057400" indent="-228600" eaLnBrk="0" hangingPunct="0"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kumimoji="1">
                    <a:solidFill>
                      <a:schemeClr val="tx1"/>
                    </a:solidFill>
                    <a:latin typeface="굴림" charset="-127"/>
                    <a:ea typeface="굴림" charset="-127"/>
                  </a:defRPr>
                </a:lvl9pPr>
              </a:lstStyle>
              <a:p>
                <a:pPr algn="r" eaLnBrk="1" hangingPunct="1"/>
                <a:r>
                  <a:rPr lang="en-US" altLang="ko-KR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Gated </a:t>
                </a:r>
                <a:r>
                  <a:rPr lang="en-US" altLang="ko-KR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on live</a:t>
                </a:r>
                <a:r>
                  <a:rPr lang="en-US" altLang="ko-KR" sz="1000" baseline="30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 </a:t>
                </a:r>
                <a:r>
                  <a:rPr lang="en-US" altLang="ko-KR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ells</a:t>
                </a:r>
              </a:p>
            </p:txBody>
          </p:sp>
          <p:cxnSp>
            <p:nvCxnSpPr>
              <p:cNvPr id="28" name="직선 연결선 27"/>
              <p:cNvCxnSpPr/>
              <p:nvPr/>
            </p:nvCxnSpPr>
            <p:spPr>
              <a:xfrm rot="5400000" flipH="1" flipV="1">
                <a:off x="408078" y="2416677"/>
                <a:ext cx="1008000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9" name="직선 연결선 28"/>
              <p:cNvCxnSpPr/>
              <p:nvPr/>
            </p:nvCxnSpPr>
            <p:spPr>
              <a:xfrm rot="5400000" flipH="1" flipV="1">
                <a:off x="408078" y="963000"/>
                <a:ext cx="1008000" cy="0"/>
              </a:xfrm>
              <a:prstGeom prst="line">
                <a:avLst/>
              </a:prstGeom>
              <a:ln w="254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grpSp>
            <p:nvGrpSpPr>
              <p:cNvPr id="98" name="그룹 97"/>
              <p:cNvGrpSpPr/>
              <p:nvPr/>
            </p:nvGrpSpPr>
            <p:grpSpPr>
              <a:xfrm>
                <a:off x="1045330" y="382081"/>
                <a:ext cx="2307541" cy="856698"/>
                <a:chOff x="1045330" y="382081"/>
                <a:chExt cx="2307541" cy="856698"/>
              </a:xfrm>
            </p:grpSpPr>
            <p:pic>
              <p:nvPicPr>
                <p:cNvPr id="6" name="Picture 7"/>
                <p:cNvPicPr>
                  <a:picLocks noChangeAspect="1" noChangeArrowheads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33060" b="33881"/>
                <a:stretch/>
              </p:blipFill>
              <p:spPr bwMode="auto">
                <a:xfrm>
                  <a:off x="1045330" y="382081"/>
                  <a:ext cx="2268638" cy="85669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30" name="TextBox 29"/>
                <p:cNvSpPr txBox="1"/>
                <p:nvPr/>
              </p:nvSpPr>
              <p:spPr bwMode="auto">
                <a:xfrm>
                  <a:off x="1822434" y="686898"/>
                  <a:ext cx="268168" cy="292488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endParaRPr lang="ko-KR" altLang="en-US" sz="8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 bwMode="auto">
                <a:xfrm>
                  <a:off x="2996025" y="672373"/>
                  <a:ext cx="268168" cy="292488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endParaRPr lang="ko-KR" altLang="en-US" sz="8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4" name="TextBox 33"/>
                <p:cNvSpPr txBox="1"/>
                <p:nvPr/>
              </p:nvSpPr>
              <p:spPr bwMode="auto">
                <a:xfrm>
                  <a:off x="1626720" y="981405"/>
                  <a:ext cx="576000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7.0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5" name="TextBox 34"/>
                <p:cNvSpPr txBox="1"/>
                <p:nvPr/>
              </p:nvSpPr>
              <p:spPr bwMode="auto">
                <a:xfrm>
                  <a:off x="2776871" y="972000"/>
                  <a:ext cx="576000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80.8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81" name="직사각형 80"/>
                <p:cNvSpPr/>
                <p:nvPr/>
              </p:nvSpPr>
              <p:spPr>
                <a:xfrm>
                  <a:off x="1059169" y="391656"/>
                  <a:ext cx="1093730" cy="824552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2" name="직사각형 81"/>
                <p:cNvSpPr/>
                <p:nvPr/>
              </p:nvSpPr>
              <p:spPr>
                <a:xfrm>
                  <a:off x="2214000" y="387000"/>
                  <a:ext cx="1093730" cy="824552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grpSp>
            <p:nvGrpSpPr>
              <p:cNvPr id="103" name="그룹 102"/>
              <p:cNvGrpSpPr/>
              <p:nvPr/>
            </p:nvGrpSpPr>
            <p:grpSpPr>
              <a:xfrm>
                <a:off x="1046158" y="1255447"/>
                <a:ext cx="2351713" cy="916247"/>
                <a:chOff x="1046158" y="1255447"/>
                <a:chExt cx="2351713" cy="916247"/>
              </a:xfrm>
            </p:grpSpPr>
            <p:pic>
              <p:nvPicPr>
                <p:cNvPr id="41" name="Picture 7"/>
                <p:cNvPicPr>
                  <a:picLocks noChangeAspect="1" noChangeArrowheads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905" b="64479"/>
                <a:stretch/>
              </p:blipFill>
              <p:spPr bwMode="auto">
                <a:xfrm>
                  <a:off x="1046158" y="1258129"/>
                  <a:ext cx="2268638" cy="91356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42" name="TextBox 41"/>
                <p:cNvSpPr txBox="1"/>
                <p:nvPr/>
              </p:nvSpPr>
              <p:spPr bwMode="auto">
                <a:xfrm>
                  <a:off x="1807050" y="1545913"/>
                  <a:ext cx="268168" cy="292488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endParaRPr lang="ko-KR" altLang="en-US" sz="8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3" name="TextBox 42"/>
                <p:cNvSpPr txBox="1"/>
                <p:nvPr/>
              </p:nvSpPr>
              <p:spPr bwMode="auto">
                <a:xfrm>
                  <a:off x="2980641" y="1512000"/>
                  <a:ext cx="268168" cy="292488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endParaRPr lang="ko-KR" altLang="en-US" sz="8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4" name="TextBox 43"/>
                <p:cNvSpPr txBox="1"/>
                <p:nvPr/>
              </p:nvSpPr>
              <p:spPr bwMode="auto">
                <a:xfrm>
                  <a:off x="1651871" y="1836556"/>
                  <a:ext cx="576000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7.4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 bwMode="auto">
                <a:xfrm>
                  <a:off x="2821871" y="1828862"/>
                  <a:ext cx="576000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 anchor="ctr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76.5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86" name="직사각형 85"/>
                <p:cNvSpPr/>
                <p:nvPr/>
              </p:nvSpPr>
              <p:spPr>
                <a:xfrm>
                  <a:off x="1054173" y="1260103"/>
                  <a:ext cx="1093730" cy="824552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7" name="직사각형 86"/>
                <p:cNvSpPr/>
                <p:nvPr/>
              </p:nvSpPr>
              <p:spPr>
                <a:xfrm>
                  <a:off x="2209004" y="1255447"/>
                  <a:ext cx="1093730" cy="824552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grpSp>
            <p:nvGrpSpPr>
              <p:cNvPr id="104" name="그룹 103"/>
              <p:cNvGrpSpPr/>
              <p:nvPr/>
            </p:nvGrpSpPr>
            <p:grpSpPr>
              <a:xfrm>
                <a:off x="1045328" y="2122129"/>
                <a:ext cx="2316543" cy="891326"/>
                <a:chOff x="1045328" y="2122129"/>
                <a:chExt cx="2316543" cy="891326"/>
              </a:xfrm>
            </p:grpSpPr>
            <p:pic>
              <p:nvPicPr>
                <p:cNvPr id="5" name="Picture 7"/>
                <p:cNvPicPr>
                  <a:picLocks noChangeAspect="1" noChangeArrowheads="1"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66625" b="-1"/>
                <a:stretch/>
              </p:blipFill>
              <p:spPr bwMode="auto">
                <a:xfrm>
                  <a:off x="1045328" y="2148564"/>
                  <a:ext cx="2268638" cy="864891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32" name="TextBox 31"/>
                <p:cNvSpPr txBox="1"/>
                <p:nvPr/>
              </p:nvSpPr>
              <p:spPr bwMode="auto">
                <a:xfrm>
                  <a:off x="1840506" y="2417045"/>
                  <a:ext cx="268168" cy="292488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endParaRPr lang="ko-KR" altLang="en-US" sz="8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 bwMode="auto">
                <a:xfrm>
                  <a:off x="2965413" y="2418964"/>
                  <a:ext cx="268168" cy="292488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endParaRPr lang="ko-KR" altLang="en-US" sz="8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6" name="TextBox 35"/>
                <p:cNvSpPr txBox="1"/>
                <p:nvPr/>
              </p:nvSpPr>
              <p:spPr bwMode="auto">
                <a:xfrm>
                  <a:off x="1651871" y="2765441"/>
                  <a:ext cx="576000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3.0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 bwMode="auto">
                <a:xfrm>
                  <a:off x="2785871" y="2764587"/>
                  <a:ext cx="576000" cy="23083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900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40.9%</a:t>
                  </a:r>
                  <a:endParaRPr lang="ko-KR" altLang="en-US" sz="9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88" name="직사각형 87"/>
                <p:cNvSpPr/>
                <p:nvPr/>
              </p:nvSpPr>
              <p:spPr>
                <a:xfrm>
                  <a:off x="1054800" y="2127448"/>
                  <a:ext cx="1093730" cy="86400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89" name="직사각형 88"/>
                <p:cNvSpPr/>
                <p:nvPr/>
              </p:nvSpPr>
              <p:spPr>
                <a:xfrm>
                  <a:off x="2198831" y="2122129"/>
                  <a:ext cx="1093730" cy="864000"/>
                </a:xfrm>
                <a:prstGeom prst="rect">
                  <a:avLst/>
                </a:prstGeom>
                <a:noFill/>
                <a:ln w="254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</p:grpSp>
          <p:sp>
            <p:nvSpPr>
              <p:cNvPr id="100" name="TextBox 99"/>
              <p:cNvSpPr txBox="1"/>
              <p:nvPr/>
            </p:nvSpPr>
            <p:spPr bwMode="auto">
              <a:xfrm>
                <a:off x="367326" y="689133"/>
                <a:ext cx="468000" cy="246221"/>
              </a:xfrm>
              <a:prstGeom prst="rect">
                <a:avLst/>
              </a:prstGeom>
              <a:noFill/>
            </p:spPr>
            <p:txBody>
              <a:bodyPr anchor="ctr">
                <a:spAutoFit/>
              </a:bodyPr>
              <a:lstStyle/>
              <a:p>
                <a:pPr algn="ctr">
                  <a:defRPr/>
                </a:pPr>
                <a:r>
                  <a:rPr lang="en-US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P</a:t>
                </a:r>
                <a:r>
                  <a:rPr lang="en-US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LN</a:t>
                </a:r>
                <a:endParaRPr lang="en-US" sz="10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 bwMode="auto">
              <a:xfrm>
                <a:off x="367326" y="1590460"/>
                <a:ext cx="468000" cy="246221"/>
              </a:xfrm>
              <a:prstGeom prst="rect">
                <a:avLst/>
              </a:prstGeom>
              <a:noFill/>
            </p:spPr>
            <p:txBody>
              <a:bodyPr anchor="ctr">
                <a:spAutoFit/>
              </a:bodyPr>
              <a:lstStyle/>
              <a:p>
                <a:pPr algn="ctr">
                  <a:defRPr/>
                </a:pPr>
                <a:r>
                  <a:rPr lang="en-US" sz="1000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MLN</a:t>
                </a:r>
                <a:endParaRPr lang="en-US" sz="1000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02" name="TextBox 101"/>
              <p:cNvSpPr txBox="1"/>
              <p:nvPr/>
            </p:nvSpPr>
            <p:spPr bwMode="auto">
              <a:xfrm>
                <a:off x="367326" y="2374230"/>
                <a:ext cx="504000" cy="400110"/>
              </a:xfrm>
              <a:prstGeom prst="rect">
                <a:avLst/>
              </a:prstGeom>
              <a:noFill/>
            </p:spPr>
            <p:txBody>
              <a:bodyPr anchor="ctr">
                <a:spAutoFit/>
              </a:bodyPr>
              <a:lstStyle/>
              <a:p>
                <a:pPr algn="ctr">
                  <a:defRPr/>
                </a:pPr>
                <a:r>
                  <a:rPr lang="en-US" sz="1000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SI-LP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642016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370</Words>
  <Application>Microsoft Office PowerPoint</Application>
  <PresentationFormat>화면 슬라이드 쇼(4:3)</PresentationFormat>
  <Paragraphs>68</Paragraphs>
  <Slides>3</Slides>
  <Notes>3</Notes>
  <HiddenSlides>0</HiddenSlides>
  <MMClips>0</MMClips>
  <ScaleCrop>false</ScaleCrop>
  <HeadingPairs>
    <vt:vector size="6" baseType="variant"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5" baseType="lpstr">
      <vt:lpstr>Office 테마</vt:lpstr>
      <vt:lpstr>Prism Project</vt:lpstr>
      <vt:lpstr>PowerPoint 프레젠테이션</vt:lpstr>
      <vt:lpstr>PowerPoint 프레젠테이션</vt:lpstr>
      <vt:lpstr>PowerPoint 프레젠테이션</vt:lpstr>
    </vt:vector>
  </TitlesOfParts>
  <Company>연세의료원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명식(의생명과학부)</dc:creator>
  <cp:lastModifiedBy>이명식(의생명과학부)</cp:lastModifiedBy>
  <cp:revision>73</cp:revision>
  <dcterms:created xsi:type="dcterms:W3CDTF">2020-02-08T03:55:59Z</dcterms:created>
  <dcterms:modified xsi:type="dcterms:W3CDTF">2020-06-26T09:25:41Z</dcterms:modified>
</cp:coreProperties>
</file>